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4"/>
  </p:notesMasterIdLst>
  <p:sldIdLst>
    <p:sldId id="408" r:id="rId2"/>
    <p:sldId id="410" r:id="rId3"/>
    <p:sldId id="402" r:id="rId4"/>
    <p:sldId id="401" r:id="rId5"/>
    <p:sldId id="386" r:id="rId6"/>
    <p:sldId id="379" r:id="rId7"/>
    <p:sldId id="375" r:id="rId8"/>
    <p:sldId id="377" r:id="rId9"/>
    <p:sldId id="412" r:id="rId10"/>
    <p:sldId id="364" r:id="rId11"/>
    <p:sldId id="365" r:id="rId12"/>
    <p:sldId id="366" r:id="rId13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25C4F4F-A66C-F4F0-AADF-B2997E8441C8}" name="Renee Salz" initials="RS" userId="S::renee.salz@radboudumc.nl::db11a661-0cdd-43f1-96ee-a0bc132d41df" providerId="AD"/>
  <p188:author id="{A7EF45AC-C83D-8DB7-4880-4AEB971A797F}" name="Salz, Renee" initials="RS" userId="S::Renee.Salz@radboudumc.nl::db11a661-0cdd-43f1-96ee-a0bc132d41df" providerId="AD"/>
  <p188:author id="{185726CB-FB64-8CF5-36F1-AD0C6CE2E1D2}" name="Vorsteveld, Emil" initials="EV" userId="S::Emil.Vorsteveld@radboudumc.nl::bc0ba57b-6ec0-4081-81cf-a71345377d75" providerId="AD"/>
  <p188:author id="{5EDE73F4-AF3B-48EB-25CF-0BE6FD424034}" name="Vorsteveld, Emil" initials="VE" userId="S::emil.vorsteveld@radboudumc.nl::bc0ba57b-6ec0-4081-81cf-a71345377d7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5161"/>
    <a:srgbClr val="B85561"/>
    <a:srgbClr val="B76469"/>
    <a:srgbClr val="B93F4F"/>
    <a:srgbClr val="BA2D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F4EAC6-C738-5143-B8E3-ABA146F0933B}" v="26" dt="2024-02-12T16:12:18.1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9"/>
    <p:restoredTop sz="95958"/>
  </p:normalViewPr>
  <p:slideViewPr>
    <p:cSldViewPr snapToGrid="0">
      <p:cViewPr>
        <p:scale>
          <a:sx n="180" d="100"/>
          <a:sy n="180" d="100"/>
        </p:scale>
        <p:origin x="664" y="310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microsoft.com/office/2018/10/relationships/authors" Target="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orsteveld, Emil" userId="bc0ba57b-6ec0-4081-81cf-a71345377d75" providerId="ADAL" clId="{78A0C87E-2A53-E043-859B-64CFC76A20D3}"/>
    <pc:docChg chg="undo custSel modSld">
      <pc:chgData name="Vorsteveld, Emil" userId="bc0ba57b-6ec0-4081-81cf-a71345377d75" providerId="ADAL" clId="{78A0C87E-2A53-E043-859B-64CFC76A20D3}" dt="2023-12-14T14:28:05.147" v="20" actId="478"/>
      <pc:docMkLst>
        <pc:docMk/>
      </pc:docMkLst>
      <pc:sldChg chg="modSp mod">
        <pc:chgData name="Vorsteveld, Emil" userId="bc0ba57b-6ec0-4081-81cf-a71345377d75" providerId="ADAL" clId="{78A0C87E-2A53-E043-859B-64CFC76A20D3}" dt="2023-12-14T14:26:56.999" v="17"/>
        <pc:sldMkLst>
          <pc:docMk/>
          <pc:sldMk cId="802137579" sldId="364"/>
        </pc:sldMkLst>
        <pc:spChg chg="mod">
          <ac:chgData name="Vorsteveld, Emil" userId="bc0ba57b-6ec0-4081-81cf-a71345377d75" providerId="ADAL" clId="{78A0C87E-2A53-E043-859B-64CFC76A20D3}" dt="2023-12-14T14:26:56.999" v="17"/>
          <ac:spMkLst>
            <pc:docMk/>
            <pc:sldMk cId="802137579" sldId="364"/>
            <ac:spMk id="2" creationId="{42FFFC56-6961-9EA7-723B-6C6F87A248DA}"/>
          </ac:spMkLst>
        </pc:spChg>
      </pc:sldChg>
      <pc:sldChg chg="modSp mod">
        <pc:chgData name="Vorsteveld, Emil" userId="bc0ba57b-6ec0-4081-81cf-a71345377d75" providerId="ADAL" clId="{78A0C87E-2A53-E043-859B-64CFC76A20D3}" dt="2023-12-14T14:26:58.864" v="18"/>
        <pc:sldMkLst>
          <pc:docMk/>
          <pc:sldMk cId="2852665802" sldId="365"/>
        </pc:sldMkLst>
        <pc:spChg chg="mod">
          <ac:chgData name="Vorsteveld, Emil" userId="bc0ba57b-6ec0-4081-81cf-a71345377d75" providerId="ADAL" clId="{78A0C87E-2A53-E043-859B-64CFC76A20D3}" dt="2023-12-14T14:26:58.864" v="18"/>
          <ac:spMkLst>
            <pc:docMk/>
            <pc:sldMk cId="2852665802" sldId="365"/>
            <ac:spMk id="2" creationId="{67CFA9C3-B82D-D66E-ADDE-2424EE080928}"/>
          </ac:spMkLst>
        </pc:spChg>
      </pc:sldChg>
      <pc:sldChg chg="modSp mod">
        <pc:chgData name="Vorsteveld, Emil" userId="bc0ba57b-6ec0-4081-81cf-a71345377d75" providerId="ADAL" clId="{78A0C87E-2A53-E043-859B-64CFC76A20D3}" dt="2023-12-14T14:27:00.437" v="19"/>
        <pc:sldMkLst>
          <pc:docMk/>
          <pc:sldMk cId="3083773218" sldId="366"/>
        </pc:sldMkLst>
        <pc:spChg chg="mod">
          <ac:chgData name="Vorsteveld, Emil" userId="bc0ba57b-6ec0-4081-81cf-a71345377d75" providerId="ADAL" clId="{78A0C87E-2A53-E043-859B-64CFC76A20D3}" dt="2023-12-14T14:27:00.437" v="19"/>
          <ac:spMkLst>
            <pc:docMk/>
            <pc:sldMk cId="3083773218" sldId="366"/>
            <ac:spMk id="2" creationId="{4A286EC3-5AF1-604E-4296-2332CEEC7658}"/>
          </ac:spMkLst>
        </pc:spChg>
      </pc:sldChg>
      <pc:sldChg chg="modSp mod">
        <pc:chgData name="Vorsteveld, Emil" userId="bc0ba57b-6ec0-4081-81cf-a71345377d75" providerId="ADAL" clId="{78A0C87E-2A53-E043-859B-64CFC76A20D3}" dt="2023-12-14T14:26:52.992" v="15"/>
        <pc:sldMkLst>
          <pc:docMk/>
          <pc:sldMk cId="699550182" sldId="375"/>
        </pc:sldMkLst>
        <pc:spChg chg="mod">
          <ac:chgData name="Vorsteveld, Emil" userId="bc0ba57b-6ec0-4081-81cf-a71345377d75" providerId="ADAL" clId="{78A0C87E-2A53-E043-859B-64CFC76A20D3}" dt="2023-12-14T14:26:52.992" v="15"/>
          <ac:spMkLst>
            <pc:docMk/>
            <pc:sldMk cId="699550182" sldId="375"/>
            <ac:spMk id="4" creationId="{123CE789-1B6D-C129-4953-DBFDCC28FF8A}"/>
          </ac:spMkLst>
        </pc:spChg>
      </pc:sldChg>
      <pc:sldChg chg="modSp mod">
        <pc:chgData name="Vorsteveld, Emil" userId="bc0ba57b-6ec0-4081-81cf-a71345377d75" providerId="ADAL" clId="{78A0C87E-2A53-E043-859B-64CFC76A20D3}" dt="2023-12-14T14:26:54.545" v="16"/>
        <pc:sldMkLst>
          <pc:docMk/>
          <pc:sldMk cId="3030647136" sldId="377"/>
        </pc:sldMkLst>
        <pc:spChg chg="mod">
          <ac:chgData name="Vorsteveld, Emil" userId="bc0ba57b-6ec0-4081-81cf-a71345377d75" providerId="ADAL" clId="{78A0C87E-2A53-E043-859B-64CFC76A20D3}" dt="2023-12-14T14:26:54.545" v="16"/>
          <ac:spMkLst>
            <pc:docMk/>
            <pc:sldMk cId="3030647136" sldId="377"/>
            <ac:spMk id="2" creationId="{DD990F44-6937-6B48-8615-B6700E069441}"/>
          </ac:spMkLst>
        </pc:spChg>
      </pc:sldChg>
      <pc:sldChg chg="modSp mod">
        <pc:chgData name="Vorsteveld, Emil" userId="bc0ba57b-6ec0-4081-81cf-a71345377d75" providerId="ADAL" clId="{78A0C87E-2A53-E043-859B-64CFC76A20D3}" dt="2023-12-14T14:26:51.260" v="14"/>
        <pc:sldMkLst>
          <pc:docMk/>
          <pc:sldMk cId="505652439" sldId="379"/>
        </pc:sldMkLst>
        <pc:spChg chg="mod">
          <ac:chgData name="Vorsteveld, Emil" userId="bc0ba57b-6ec0-4081-81cf-a71345377d75" providerId="ADAL" clId="{78A0C87E-2A53-E043-859B-64CFC76A20D3}" dt="2023-12-14T14:26:51.260" v="14"/>
          <ac:spMkLst>
            <pc:docMk/>
            <pc:sldMk cId="505652439" sldId="379"/>
            <ac:spMk id="2" creationId="{4536EC2E-FC87-3953-DFAB-68600ABD0F7F}"/>
          </ac:spMkLst>
        </pc:spChg>
      </pc:sldChg>
      <pc:sldChg chg="modSp mod">
        <pc:chgData name="Vorsteveld, Emil" userId="bc0ba57b-6ec0-4081-81cf-a71345377d75" providerId="ADAL" clId="{78A0C87E-2A53-E043-859B-64CFC76A20D3}" dt="2023-12-14T14:26:49.246" v="13"/>
        <pc:sldMkLst>
          <pc:docMk/>
          <pc:sldMk cId="2534231057" sldId="386"/>
        </pc:sldMkLst>
        <pc:spChg chg="mod">
          <ac:chgData name="Vorsteveld, Emil" userId="bc0ba57b-6ec0-4081-81cf-a71345377d75" providerId="ADAL" clId="{78A0C87E-2A53-E043-859B-64CFC76A20D3}" dt="2023-12-14T14:26:49.246" v="13"/>
          <ac:spMkLst>
            <pc:docMk/>
            <pc:sldMk cId="2534231057" sldId="386"/>
            <ac:spMk id="4" creationId="{1D004A7C-7E96-1C35-76AF-173E8D6314BB}"/>
          </ac:spMkLst>
        </pc:spChg>
      </pc:sldChg>
      <pc:sldChg chg="modSp mod">
        <pc:chgData name="Vorsteveld, Emil" userId="bc0ba57b-6ec0-4081-81cf-a71345377d75" providerId="ADAL" clId="{78A0C87E-2A53-E043-859B-64CFC76A20D3}" dt="2023-12-14T14:25:33.587" v="7"/>
        <pc:sldMkLst>
          <pc:docMk/>
          <pc:sldMk cId="3910950501" sldId="401"/>
        </pc:sldMkLst>
        <pc:spChg chg="mod">
          <ac:chgData name="Vorsteveld, Emil" userId="bc0ba57b-6ec0-4081-81cf-a71345377d75" providerId="ADAL" clId="{78A0C87E-2A53-E043-859B-64CFC76A20D3}" dt="2023-12-14T14:25:33.587" v="7"/>
          <ac:spMkLst>
            <pc:docMk/>
            <pc:sldMk cId="3910950501" sldId="401"/>
            <ac:spMk id="2" creationId="{3E76F37E-58A9-2A2C-F797-7F055999A749}"/>
          </ac:spMkLst>
        </pc:spChg>
      </pc:sldChg>
      <pc:sldChg chg="modSp mod">
        <pc:chgData name="Vorsteveld, Emil" userId="bc0ba57b-6ec0-4081-81cf-a71345377d75" providerId="ADAL" clId="{78A0C87E-2A53-E043-859B-64CFC76A20D3}" dt="2023-12-14T14:26:45.854" v="12"/>
        <pc:sldMkLst>
          <pc:docMk/>
          <pc:sldMk cId="823690444" sldId="402"/>
        </pc:sldMkLst>
        <pc:spChg chg="mod">
          <ac:chgData name="Vorsteveld, Emil" userId="bc0ba57b-6ec0-4081-81cf-a71345377d75" providerId="ADAL" clId="{78A0C87E-2A53-E043-859B-64CFC76A20D3}" dt="2023-12-14T14:26:45.854" v="12"/>
          <ac:spMkLst>
            <pc:docMk/>
            <pc:sldMk cId="823690444" sldId="402"/>
            <ac:spMk id="4" creationId="{F2EC2135-59D7-53AD-3CD3-C4B873121DEB}"/>
          </ac:spMkLst>
        </pc:spChg>
      </pc:sldChg>
      <pc:sldChg chg="delSp modSp mod">
        <pc:chgData name="Vorsteveld, Emil" userId="bc0ba57b-6ec0-4081-81cf-a71345377d75" providerId="ADAL" clId="{78A0C87E-2A53-E043-859B-64CFC76A20D3}" dt="2023-12-14T14:28:05.147" v="20" actId="478"/>
        <pc:sldMkLst>
          <pc:docMk/>
          <pc:sldMk cId="3723467650" sldId="408"/>
        </pc:sldMkLst>
        <pc:spChg chg="mod">
          <ac:chgData name="Vorsteveld, Emil" userId="bc0ba57b-6ec0-4081-81cf-a71345377d75" providerId="ADAL" clId="{78A0C87E-2A53-E043-859B-64CFC76A20D3}" dt="2023-12-14T14:26:42.930" v="10"/>
          <ac:spMkLst>
            <pc:docMk/>
            <pc:sldMk cId="3723467650" sldId="408"/>
            <ac:spMk id="3" creationId="{138F32E2-9CB5-2F39-8640-F4C46CCF34D6}"/>
          </ac:spMkLst>
        </pc:spChg>
        <pc:spChg chg="del">
          <ac:chgData name="Vorsteveld, Emil" userId="bc0ba57b-6ec0-4081-81cf-a71345377d75" providerId="ADAL" clId="{78A0C87E-2A53-E043-859B-64CFC76A20D3}" dt="2023-12-14T14:28:05.147" v="20" actId="478"/>
          <ac:spMkLst>
            <pc:docMk/>
            <pc:sldMk cId="3723467650" sldId="408"/>
            <ac:spMk id="10" creationId="{5EF04E08-844F-AC58-430D-C5557D07E213}"/>
          </ac:spMkLst>
        </pc:spChg>
      </pc:sldChg>
      <pc:sldChg chg="modSp mod">
        <pc:chgData name="Vorsteveld, Emil" userId="bc0ba57b-6ec0-4081-81cf-a71345377d75" providerId="ADAL" clId="{78A0C87E-2A53-E043-859B-64CFC76A20D3}" dt="2023-12-14T14:26:44.260" v="11"/>
        <pc:sldMkLst>
          <pc:docMk/>
          <pc:sldMk cId="3389440866" sldId="410"/>
        </pc:sldMkLst>
        <pc:spChg chg="mod">
          <ac:chgData name="Vorsteveld, Emil" userId="bc0ba57b-6ec0-4081-81cf-a71345377d75" providerId="ADAL" clId="{78A0C87E-2A53-E043-859B-64CFC76A20D3}" dt="2023-12-14T14:26:44.260" v="11"/>
          <ac:spMkLst>
            <pc:docMk/>
            <pc:sldMk cId="3389440866" sldId="410"/>
            <ac:spMk id="2" creationId="{7D3F00A1-E897-9457-AA1B-FD354F47E6EC}"/>
          </ac:spMkLst>
        </pc:spChg>
      </pc:sldChg>
    </pc:docChg>
  </pc:docChgLst>
  <pc:docChgLst>
    <pc:chgData name="Vorsteveld, Emil" userId="bc0ba57b-6ec0-4081-81cf-a71345377d75" providerId="ADAL" clId="{0E4AE27B-7F78-224C-8D17-AF3265819DF0}"/>
    <pc:docChg chg="custSel modSld">
      <pc:chgData name="Vorsteveld, Emil" userId="bc0ba57b-6ec0-4081-81cf-a71345377d75" providerId="ADAL" clId="{0E4AE27B-7F78-224C-8D17-AF3265819DF0}" dt="2023-10-04T10:30:05.259" v="30" actId="1076"/>
      <pc:docMkLst>
        <pc:docMk/>
      </pc:docMkLst>
      <pc:sldChg chg="delSp modSp mod">
        <pc:chgData name="Vorsteveld, Emil" userId="bc0ba57b-6ec0-4081-81cf-a71345377d75" providerId="ADAL" clId="{0E4AE27B-7F78-224C-8D17-AF3265819DF0}" dt="2023-10-04T10:29:53.060" v="28" actId="6549"/>
        <pc:sldMkLst>
          <pc:docMk/>
          <pc:sldMk cId="802137579" sldId="364"/>
        </pc:sldMkLst>
        <pc:spChg chg="del">
          <ac:chgData name="Vorsteveld, Emil" userId="bc0ba57b-6ec0-4081-81cf-a71345377d75" providerId="ADAL" clId="{0E4AE27B-7F78-224C-8D17-AF3265819DF0}" dt="2023-10-04T10:27:59.701" v="2" actId="478"/>
          <ac:spMkLst>
            <pc:docMk/>
            <pc:sldMk cId="802137579" sldId="364"/>
            <ac:spMk id="3" creationId="{23308F0D-2CAB-6541-9782-307952D3AAB8}"/>
          </ac:spMkLst>
        </pc:spChg>
        <pc:spChg chg="mod">
          <ac:chgData name="Vorsteveld, Emil" userId="bc0ba57b-6ec0-4081-81cf-a71345377d75" providerId="ADAL" clId="{0E4AE27B-7F78-224C-8D17-AF3265819DF0}" dt="2023-10-04T10:29:48.566" v="24" actId="6549"/>
          <ac:spMkLst>
            <pc:docMk/>
            <pc:sldMk cId="802137579" sldId="364"/>
            <ac:spMk id="6" creationId="{9D743D87-DF23-95ED-454E-7E2EDCE8934F}"/>
          </ac:spMkLst>
        </pc:spChg>
        <pc:spChg chg="mod">
          <ac:chgData name="Vorsteveld, Emil" userId="bc0ba57b-6ec0-4081-81cf-a71345377d75" providerId="ADAL" clId="{0E4AE27B-7F78-224C-8D17-AF3265819DF0}" dt="2023-10-04T10:29:51.279" v="27" actId="6549"/>
          <ac:spMkLst>
            <pc:docMk/>
            <pc:sldMk cId="802137579" sldId="364"/>
            <ac:spMk id="7" creationId="{FD77B6A7-D129-F494-E4DF-C15AF47DE637}"/>
          </ac:spMkLst>
        </pc:spChg>
        <pc:spChg chg="mod">
          <ac:chgData name="Vorsteveld, Emil" userId="bc0ba57b-6ec0-4081-81cf-a71345377d75" providerId="ADAL" clId="{0E4AE27B-7F78-224C-8D17-AF3265819DF0}" dt="2023-10-04T10:29:53.060" v="28" actId="6549"/>
          <ac:spMkLst>
            <pc:docMk/>
            <pc:sldMk cId="802137579" sldId="364"/>
            <ac:spMk id="8" creationId="{7EDDAA5C-F1E3-EDEB-9CDA-747EBE1E50FE}"/>
          </ac:spMkLst>
        </pc:spChg>
      </pc:sldChg>
      <pc:sldChg chg="addSp delSp modSp mod">
        <pc:chgData name="Vorsteveld, Emil" userId="bc0ba57b-6ec0-4081-81cf-a71345377d75" providerId="ADAL" clId="{0E4AE27B-7F78-224C-8D17-AF3265819DF0}" dt="2023-10-04T10:30:05.259" v="30" actId="1076"/>
        <pc:sldMkLst>
          <pc:docMk/>
          <pc:sldMk cId="2852665802" sldId="365"/>
        </pc:sldMkLst>
        <pc:spChg chg="del">
          <ac:chgData name="Vorsteveld, Emil" userId="bc0ba57b-6ec0-4081-81cf-a71345377d75" providerId="ADAL" clId="{0E4AE27B-7F78-224C-8D17-AF3265819DF0}" dt="2023-10-04T10:27:57.692" v="1" actId="478"/>
          <ac:spMkLst>
            <pc:docMk/>
            <pc:sldMk cId="2852665802" sldId="365"/>
            <ac:spMk id="3" creationId="{94027D2F-120A-C35E-7A75-794AEECA5DAE}"/>
          </ac:spMkLst>
        </pc:spChg>
        <pc:spChg chg="add mod">
          <ac:chgData name="Vorsteveld, Emil" userId="bc0ba57b-6ec0-4081-81cf-a71345377d75" providerId="ADAL" clId="{0E4AE27B-7F78-224C-8D17-AF3265819DF0}" dt="2023-10-04T10:30:05.259" v="30" actId="1076"/>
          <ac:spMkLst>
            <pc:docMk/>
            <pc:sldMk cId="2852665802" sldId="365"/>
            <ac:spMk id="6" creationId="{37B1A0BE-7594-E5F5-FFDD-A9CBCF162D23}"/>
          </ac:spMkLst>
        </pc:spChg>
        <pc:spChg chg="add mod">
          <ac:chgData name="Vorsteveld, Emil" userId="bc0ba57b-6ec0-4081-81cf-a71345377d75" providerId="ADAL" clId="{0E4AE27B-7F78-224C-8D17-AF3265819DF0}" dt="2023-10-04T10:30:05.259" v="30" actId="1076"/>
          <ac:spMkLst>
            <pc:docMk/>
            <pc:sldMk cId="2852665802" sldId="365"/>
            <ac:spMk id="7" creationId="{DA683A3B-5EF3-FCC3-4D3C-4D7843658FCA}"/>
          </ac:spMkLst>
        </pc:spChg>
      </pc:sldChg>
      <pc:sldChg chg="delSp mod">
        <pc:chgData name="Vorsteveld, Emil" userId="bc0ba57b-6ec0-4081-81cf-a71345377d75" providerId="ADAL" clId="{0E4AE27B-7F78-224C-8D17-AF3265819DF0}" dt="2023-10-04T10:27:55.470" v="0" actId="478"/>
        <pc:sldMkLst>
          <pc:docMk/>
          <pc:sldMk cId="3083773218" sldId="366"/>
        </pc:sldMkLst>
        <pc:spChg chg="del">
          <ac:chgData name="Vorsteveld, Emil" userId="bc0ba57b-6ec0-4081-81cf-a71345377d75" providerId="ADAL" clId="{0E4AE27B-7F78-224C-8D17-AF3265819DF0}" dt="2023-10-04T10:27:55.470" v="0" actId="478"/>
          <ac:spMkLst>
            <pc:docMk/>
            <pc:sldMk cId="3083773218" sldId="366"/>
            <ac:spMk id="3" creationId="{A5D78140-0B8A-481A-B0BC-C4B7A2C77881}"/>
          </ac:spMkLst>
        </pc:spChg>
      </pc:sldChg>
      <pc:sldChg chg="delSp mod delCm">
        <pc:chgData name="Vorsteveld, Emil" userId="bc0ba57b-6ec0-4081-81cf-a71345377d75" providerId="ADAL" clId="{0E4AE27B-7F78-224C-8D17-AF3265819DF0}" dt="2023-10-04T10:28:22.112" v="9"/>
        <pc:sldMkLst>
          <pc:docMk/>
          <pc:sldMk cId="699550182" sldId="375"/>
        </pc:sldMkLst>
        <pc:spChg chg="del">
          <ac:chgData name="Vorsteveld, Emil" userId="bc0ba57b-6ec0-4081-81cf-a71345377d75" providerId="ADAL" clId="{0E4AE27B-7F78-224C-8D17-AF3265819DF0}" dt="2023-10-04T10:28:04.180" v="4" actId="478"/>
          <ac:spMkLst>
            <pc:docMk/>
            <pc:sldMk cId="699550182" sldId="375"/>
            <ac:spMk id="2" creationId="{82504FE4-17F5-4B37-B277-394BE191145C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Vorsteveld, Emil" userId="bc0ba57b-6ec0-4081-81cf-a71345377d75" providerId="ADAL" clId="{0E4AE27B-7F78-224C-8D17-AF3265819DF0}" dt="2023-10-04T10:28:22.112" v="9"/>
              <pc2:cmMkLst xmlns:pc2="http://schemas.microsoft.com/office/powerpoint/2019/9/main/command">
                <pc:docMk/>
                <pc:sldMk cId="699550182" sldId="375"/>
                <pc2:cmMk id="{76C8BD21-0C86-DA46-BA32-9088E5D72D46}"/>
              </pc2:cmMkLst>
            </pc226:cmChg>
          </p:ext>
        </pc:extLst>
      </pc:sldChg>
      <pc:sldChg chg="addSp delSp modSp mod">
        <pc:chgData name="Vorsteveld, Emil" userId="bc0ba57b-6ec0-4081-81cf-a71345377d75" providerId="ADAL" clId="{0E4AE27B-7F78-224C-8D17-AF3265819DF0}" dt="2023-10-04T10:29:41.028" v="23" actId="1076"/>
        <pc:sldMkLst>
          <pc:docMk/>
          <pc:sldMk cId="3030647136" sldId="377"/>
        </pc:sldMkLst>
        <pc:spChg chg="add mod">
          <ac:chgData name="Vorsteveld, Emil" userId="bc0ba57b-6ec0-4081-81cf-a71345377d75" providerId="ADAL" clId="{0E4AE27B-7F78-224C-8D17-AF3265819DF0}" dt="2023-10-04T10:29:35.868" v="22" actId="1076"/>
          <ac:spMkLst>
            <pc:docMk/>
            <pc:sldMk cId="3030647136" sldId="377"/>
            <ac:spMk id="3" creationId="{3329794D-F027-EBB3-4B3A-A7219E531D3C}"/>
          </ac:spMkLst>
        </pc:spChg>
        <pc:spChg chg="add mod">
          <ac:chgData name="Vorsteveld, Emil" userId="bc0ba57b-6ec0-4081-81cf-a71345377d75" providerId="ADAL" clId="{0E4AE27B-7F78-224C-8D17-AF3265819DF0}" dt="2023-10-04T10:29:41.028" v="23" actId="1076"/>
          <ac:spMkLst>
            <pc:docMk/>
            <pc:sldMk cId="3030647136" sldId="377"/>
            <ac:spMk id="4" creationId="{364DFD38-983B-4FBA-BE3C-81A7E31E4681}"/>
          </ac:spMkLst>
        </pc:spChg>
        <pc:spChg chg="del">
          <ac:chgData name="Vorsteveld, Emil" userId="bc0ba57b-6ec0-4081-81cf-a71345377d75" providerId="ADAL" clId="{0E4AE27B-7F78-224C-8D17-AF3265819DF0}" dt="2023-10-04T10:28:01.764" v="3" actId="478"/>
          <ac:spMkLst>
            <pc:docMk/>
            <pc:sldMk cId="3030647136" sldId="377"/>
            <ac:spMk id="9" creationId="{2C6365E4-0D62-F24B-EE86-F3DC1397B44A}"/>
          </ac:spMkLst>
        </pc:spChg>
      </pc:sldChg>
      <pc:sldChg chg="delSp modSp mod delCm modNotesTx">
        <pc:chgData name="Vorsteveld, Emil" userId="bc0ba57b-6ec0-4081-81cf-a71345377d75" providerId="ADAL" clId="{0E4AE27B-7F78-224C-8D17-AF3265819DF0}" dt="2023-10-04T10:28:14.391" v="8" actId="20577"/>
        <pc:sldMkLst>
          <pc:docMk/>
          <pc:sldMk cId="505652439" sldId="379"/>
        </pc:sldMkLst>
        <pc:spChg chg="del mod">
          <ac:chgData name="Vorsteveld, Emil" userId="bc0ba57b-6ec0-4081-81cf-a71345377d75" providerId="ADAL" clId="{0E4AE27B-7F78-224C-8D17-AF3265819DF0}" dt="2023-10-04T10:28:11.135" v="7" actId="478"/>
          <ac:spMkLst>
            <pc:docMk/>
            <pc:sldMk cId="505652439" sldId="379"/>
            <ac:spMk id="5" creationId="{DA8232B5-0D78-5C4C-CCF2-E32A947AAA57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Vorsteveld, Emil" userId="bc0ba57b-6ec0-4081-81cf-a71345377d75" providerId="ADAL" clId="{0E4AE27B-7F78-224C-8D17-AF3265819DF0}" dt="2023-10-04T10:28:09.293" v="5"/>
              <pc2:cmMkLst xmlns:pc2="http://schemas.microsoft.com/office/powerpoint/2019/9/main/command">
                <pc:docMk/>
                <pc:sldMk cId="505652439" sldId="379"/>
                <pc2:cmMk id="{DD17AC02-ACC9-2C4B-B3D9-FC2C2BB9DE5A}"/>
              </pc2:cmMkLst>
            </pc226:cmChg>
          </p:ext>
        </pc:extLst>
      </pc:sldChg>
      <pc:sldChg chg="addSp delSp modSp mod">
        <pc:chgData name="Vorsteveld, Emil" userId="bc0ba57b-6ec0-4081-81cf-a71345377d75" providerId="ADAL" clId="{0E4AE27B-7F78-224C-8D17-AF3265819DF0}" dt="2023-10-04T10:29:15.262" v="20" actId="1076"/>
        <pc:sldMkLst>
          <pc:docMk/>
          <pc:sldMk cId="2534231057" sldId="386"/>
        </pc:sldMkLst>
        <pc:spChg chg="add mod">
          <ac:chgData name="Vorsteveld, Emil" userId="bc0ba57b-6ec0-4081-81cf-a71345377d75" providerId="ADAL" clId="{0E4AE27B-7F78-224C-8D17-AF3265819DF0}" dt="2023-10-04T10:29:02.417" v="18" actId="1076"/>
          <ac:spMkLst>
            <pc:docMk/>
            <pc:sldMk cId="2534231057" sldId="386"/>
            <ac:spMk id="2" creationId="{C6BE9C28-0BA1-16BC-4649-92EF0F5F4D7C}"/>
          </ac:spMkLst>
        </pc:spChg>
        <pc:spChg chg="add mod">
          <ac:chgData name="Vorsteveld, Emil" userId="bc0ba57b-6ec0-4081-81cf-a71345377d75" providerId="ADAL" clId="{0E4AE27B-7F78-224C-8D17-AF3265819DF0}" dt="2023-10-04T10:29:13.776" v="19" actId="1076"/>
          <ac:spMkLst>
            <pc:docMk/>
            <pc:sldMk cId="2534231057" sldId="386"/>
            <ac:spMk id="5" creationId="{B656D317-C7DF-AF83-3A5F-67BF228021B8}"/>
          </ac:spMkLst>
        </pc:spChg>
        <pc:spChg chg="del">
          <ac:chgData name="Vorsteveld, Emil" userId="bc0ba57b-6ec0-4081-81cf-a71345377d75" providerId="ADAL" clId="{0E4AE27B-7F78-224C-8D17-AF3265819DF0}" dt="2023-10-04T10:28:25.678" v="10" actId="478"/>
          <ac:spMkLst>
            <pc:docMk/>
            <pc:sldMk cId="2534231057" sldId="386"/>
            <ac:spMk id="7" creationId="{D877421C-20B7-6895-DB25-B97D291E3A17}"/>
          </ac:spMkLst>
        </pc:spChg>
        <pc:picChg chg="mod">
          <ac:chgData name="Vorsteveld, Emil" userId="bc0ba57b-6ec0-4081-81cf-a71345377d75" providerId="ADAL" clId="{0E4AE27B-7F78-224C-8D17-AF3265819DF0}" dt="2023-10-04T10:29:15.262" v="20" actId="1076"/>
          <ac:picMkLst>
            <pc:docMk/>
            <pc:sldMk cId="2534231057" sldId="386"/>
            <ac:picMk id="6" creationId="{9C3C21D3-6123-7F2F-E765-850FDD87E7BB}"/>
          </ac:picMkLst>
        </pc:picChg>
      </pc:sldChg>
      <pc:sldChg chg="delSp mod">
        <pc:chgData name="Vorsteveld, Emil" userId="bc0ba57b-6ec0-4081-81cf-a71345377d75" providerId="ADAL" clId="{0E4AE27B-7F78-224C-8D17-AF3265819DF0}" dt="2023-10-04T10:28:55.043" v="16" actId="478"/>
        <pc:sldMkLst>
          <pc:docMk/>
          <pc:sldMk cId="3910950501" sldId="401"/>
        </pc:sldMkLst>
        <pc:spChg chg="del">
          <ac:chgData name="Vorsteveld, Emil" userId="bc0ba57b-6ec0-4081-81cf-a71345377d75" providerId="ADAL" clId="{0E4AE27B-7F78-224C-8D17-AF3265819DF0}" dt="2023-10-04T10:28:55.043" v="16" actId="478"/>
          <ac:spMkLst>
            <pc:docMk/>
            <pc:sldMk cId="3910950501" sldId="401"/>
            <ac:spMk id="19" creationId="{E6F92230-6F5D-A67C-4321-7C328EBB7AB0}"/>
          </ac:spMkLst>
        </pc:spChg>
      </pc:sldChg>
      <pc:sldChg chg="delSp mod">
        <pc:chgData name="Vorsteveld, Emil" userId="bc0ba57b-6ec0-4081-81cf-a71345377d75" providerId="ADAL" clId="{0E4AE27B-7F78-224C-8D17-AF3265819DF0}" dt="2023-10-04T10:28:52.041" v="15" actId="478"/>
        <pc:sldMkLst>
          <pc:docMk/>
          <pc:sldMk cId="823690444" sldId="402"/>
        </pc:sldMkLst>
        <pc:spChg chg="del">
          <ac:chgData name="Vorsteveld, Emil" userId="bc0ba57b-6ec0-4081-81cf-a71345377d75" providerId="ADAL" clId="{0E4AE27B-7F78-224C-8D17-AF3265819DF0}" dt="2023-10-04T10:28:52.041" v="15" actId="478"/>
          <ac:spMkLst>
            <pc:docMk/>
            <pc:sldMk cId="823690444" sldId="402"/>
            <ac:spMk id="8" creationId="{B2FE4C80-FE2D-D3FB-ADB3-9BF7A9651C63}"/>
          </ac:spMkLst>
        </pc:spChg>
      </pc:sldChg>
      <pc:sldChg chg="addSp delSp modSp mod">
        <pc:chgData name="Vorsteveld, Emil" userId="bc0ba57b-6ec0-4081-81cf-a71345377d75" providerId="ADAL" clId="{0E4AE27B-7F78-224C-8D17-AF3265819DF0}" dt="2023-10-04T10:28:42.762" v="14" actId="478"/>
        <pc:sldMkLst>
          <pc:docMk/>
          <pc:sldMk cId="3389440866" sldId="410"/>
        </pc:sldMkLst>
        <pc:spChg chg="add mod">
          <ac:chgData name="Vorsteveld, Emil" userId="bc0ba57b-6ec0-4081-81cf-a71345377d75" providerId="ADAL" clId="{0E4AE27B-7F78-224C-8D17-AF3265819DF0}" dt="2023-10-04T10:28:38.602" v="12" actId="1076"/>
          <ac:spMkLst>
            <pc:docMk/>
            <pc:sldMk cId="3389440866" sldId="410"/>
            <ac:spMk id="3" creationId="{71744620-807D-159A-12FC-A633798B7109}"/>
          </ac:spMkLst>
        </pc:spChg>
        <pc:spChg chg="del">
          <ac:chgData name="Vorsteveld, Emil" userId="bc0ba57b-6ec0-4081-81cf-a71345377d75" providerId="ADAL" clId="{0E4AE27B-7F78-224C-8D17-AF3265819DF0}" dt="2023-10-04T10:28:42.762" v="14" actId="478"/>
          <ac:spMkLst>
            <pc:docMk/>
            <pc:sldMk cId="3389440866" sldId="410"/>
            <ac:spMk id="6" creationId="{AFE539B0-BA95-C6A1-86EF-A248BC52D06C}"/>
          </ac:spMkLst>
        </pc:spChg>
        <pc:spChg chg="add mod">
          <ac:chgData name="Vorsteveld, Emil" userId="bc0ba57b-6ec0-4081-81cf-a71345377d75" providerId="ADAL" clId="{0E4AE27B-7F78-224C-8D17-AF3265819DF0}" dt="2023-10-04T10:28:41.161" v="13" actId="1076"/>
          <ac:spMkLst>
            <pc:docMk/>
            <pc:sldMk cId="3389440866" sldId="410"/>
            <ac:spMk id="7" creationId="{0B648B6A-7085-C5D9-0A79-68DD537749E8}"/>
          </ac:spMkLst>
        </pc:spChg>
      </pc:sldChg>
    </pc:docChg>
  </pc:docChgLst>
  <pc:docChgLst>
    <pc:chgData name="Vorsteveld, Emil" userId="bc0ba57b-6ec0-4081-81cf-a71345377d75" providerId="ADAL" clId="{02F4EAC6-C738-5143-B8E3-ABA146F0933B}"/>
    <pc:docChg chg="undo custSel addSld delSld modSld">
      <pc:chgData name="Vorsteveld, Emil" userId="bc0ba57b-6ec0-4081-81cf-a71345377d75" providerId="ADAL" clId="{02F4EAC6-C738-5143-B8E3-ABA146F0933B}" dt="2024-02-14T12:13:21.550" v="286" actId="2696"/>
      <pc:docMkLst>
        <pc:docMk/>
      </pc:docMkLst>
      <pc:sldChg chg="modSp mod">
        <pc:chgData name="Vorsteveld, Emil" userId="bc0ba57b-6ec0-4081-81cf-a71345377d75" providerId="ADAL" clId="{02F4EAC6-C738-5143-B8E3-ABA146F0933B}" dt="2024-02-08T08:55:42.078" v="199" actId="20577"/>
        <pc:sldMkLst>
          <pc:docMk/>
          <pc:sldMk cId="802137579" sldId="364"/>
        </pc:sldMkLst>
        <pc:spChg chg="mod">
          <ac:chgData name="Vorsteveld, Emil" userId="bc0ba57b-6ec0-4081-81cf-a71345377d75" providerId="ADAL" clId="{02F4EAC6-C738-5143-B8E3-ABA146F0933B}" dt="2024-02-08T08:55:42.078" v="199" actId="20577"/>
          <ac:spMkLst>
            <pc:docMk/>
            <pc:sldMk cId="802137579" sldId="364"/>
            <ac:spMk id="2" creationId="{42FFFC56-6961-9EA7-723B-6C6F87A248DA}"/>
          </ac:spMkLst>
        </pc:spChg>
      </pc:sldChg>
      <pc:sldChg chg="modSp mod">
        <pc:chgData name="Vorsteveld, Emil" userId="bc0ba57b-6ec0-4081-81cf-a71345377d75" providerId="ADAL" clId="{02F4EAC6-C738-5143-B8E3-ABA146F0933B}" dt="2024-02-08T08:55:44.303" v="201" actId="20577"/>
        <pc:sldMkLst>
          <pc:docMk/>
          <pc:sldMk cId="2852665802" sldId="365"/>
        </pc:sldMkLst>
        <pc:spChg chg="mod">
          <ac:chgData name="Vorsteveld, Emil" userId="bc0ba57b-6ec0-4081-81cf-a71345377d75" providerId="ADAL" clId="{02F4EAC6-C738-5143-B8E3-ABA146F0933B}" dt="2024-02-08T08:55:44.303" v="201" actId="20577"/>
          <ac:spMkLst>
            <pc:docMk/>
            <pc:sldMk cId="2852665802" sldId="365"/>
            <ac:spMk id="2" creationId="{67CFA9C3-B82D-D66E-ADDE-2424EE080928}"/>
          </ac:spMkLst>
        </pc:spChg>
      </pc:sldChg>
      <pc:sldChg chg="addSp delSp modSp mod">
        <pc:chgData name="Vorsteveld, Emil" userId="bc0ba57b-6ec0-4081-81cf-a71345377d75" providerId="ADAL" clId="{02F4EAC6-C738-5143-B8E3-ABA146F0933B}" dt="2024-02-08T08:55:46.644" v="203" actId="20577"/>
        <pc:sldMkLst>
          <pc:docMk/>
          <pc:sldMk cId="3083773218" sldId="366"/>
        </pc:sldMkLst>
        <pc:spChg chg="mod">
          <ac:chgData name="Vorsteveld, Emil" userId="bc0ba57b-6ec0-4081-81cf-a71345377d75" providerId="ADAL" clId="{02F4EAC6-C738-5143-B8E3-ABA146F0933B}" dt="2024-02-08T08:55:46.644" v="203" actId="20577"/>
          <ac:spMkLst>
            <pc:docMk/>
            <pc:sldMk cId="3083773218" sldId="366"/>
            <ac:spMk id="2" creationId="{4A286EC3-5AF1-604E-4296-2332CEEC7658}"/>
          </ac:spMkLst>
        </pc:spChg>
        <pc:picChg chg="add mod">
          <ac:chgData name="Vorsteveld, Emil" userId="bc0ba57b-6ec0-4081-81cf-a71345377d75" providerId="ADAL" clId="{02F4EAC6-C738-5143-B8E3-ABA146F0933B}" dt="2024-02-05T17:12:36.051" v="96" actId="1076"/>
          <ac:picMkLst>
            <pc:docMk/>
            <pc:sldMk cId="3083773218" sldId="366"/>
            <ac:picMk id="3" creationId="{30CCD018-13B2-D9C4-F891-477D5AD16FE8}"/>
          </ac:picMkLst>
        </pc:picChg>
        <pc:picChg chg="del">
          <ac:chgData name="Vorsteveld, Emil" userId="bc0ba57b-6ec0-4081-81cf-a71345377d75" providerId="ADAL" clId="{02F4EAC6-C738-5143-B8E3-ABA146F0933B}" dt="2024-02-05T17:12:28.638" v="91" actId="478"/>
          <ac:picMkLst>
            <pc:docMk/>
            <pc:sldMk cId="3083773218" sldId="366"/>
            <ac:picMk id="9" creationId="{A6AE6FDE-A48E-F6EC-1490-06933D896FD7}"/>
          </ac:picMkLst>
        </pc:picChg>
        <pc:picChg chg="del">
          <ac:chgData name="Vorsteveld, Emil" userId="bc0ba57b-6ec0-4081-81cf-a71345377d75" providerId="ADAL" clId="{02F4EAC6-C738-5143-B8E3-ABA146F0933B}" dt="2024-02-05T17:12:29.024" v="92" actId="478"/>
          <ac:picMkLst>
            <pc:docMk/>
            <pc:sldMk cId="3083773218" sldId="366"/>
            <ac:picMk id="10" creationId="{ADD0C43D-DB81-910F-F4F7-BB84008EE1ED}"/>
          </ac:picMkLst>
        </pc:picChg>
      </pc:sldChg>
      <pc:sldChg chg="addSp delSp modSp mod">
        <pc:chgData name="Vorsteveld, Emil" userId="bc0ba57b-6ec0-4081-81cf-a71345377d75" providerId="ADAL" clId="{02F4EAC6-C738-5143-B8E3-ABA146F0933B}" dt="2024-02-09T12:23:59.907" v="228" actId="1076"/>
        <pc:sldMkLst>
          <pc:docMk/>
          <pc:sldMk cId="505652439" sldId="379"/>
        </pc:sldMkLst>
        <pc:spChg chg="mod">
          <ac:chgData name="Vorsteveld, Emil" userId="bc0ba57b-6ec0-4081-81cf-a71345377d75" providerId="ADAL" clId="{02F4EAC6-C738-5143-B8E3-ABA146F0933B}" dt="2024-02-08T08:54:22.525" v="170" actId="20577"/>
          <ac:spMkLst>
            <pc:docMk/>
            <pc:sldMk cId="505652439" sldId="379"/>
            <ac:spMk id="7" creationId="{30E14A5F-2234-462B-F6FC-77F2A613212A}"/>
          </ac:spMkLst>
        </pc:spChg>
        <pc:spChg chg="mod">
          <ac:chgData name="Vorsteveld, Emil" userId="bc0ba57b-6ec0-4081-81cf-a71345377d75" providerId="ADAL" clId="{02F4EAC6-C738-5143-B8E3-ABA146F0933B}" dt="2024-02-08T08:54:26.514" v="171" actId="20577"/>
          <ac:spMkLst>
            <pc:docMk/>
            <pc:sldMk cId="505652439" sldId="379"/>
            <ac:spMk id="8" creationId="{B158E59B-F5AC-B8FB-217F-95B4A5B7F8B6}"/>
          </ac:spMkLst>
        </pc:spChg>
        <pc:spChg chg="mod">
          <ac:chgData name="Vorsteveld, Emil" userId="bc0ba57b-6ec0-4081-81cf-a71345377d75" providerId="ADAL" clId="{02F4EAC6-C738-5143-B8E3-ABA146F0933B}" dt="2024-02-08T08:54:28.554" v="172" actId="20577"/>
          <ac:spMkLst>
            <pc:docMk/>
            <pc:sldMk cId="505652439" sldId="379"/>
            <ac:spMk id="9" creationId="{E3AC24EF-D664-CB6F-8892-4657AEF68BF1}"/>
          </ac:spMkLst>
        </pc:spChg>
        <pc:spChg chg="add mod">
          <ac:chgData name="Vorsteveld, Emil" userId="bc0ba57b-6ec0-4081-81cf-a71345377d75" providerId="ADAL" clId="{02F4EAC6-C738-5143-B8E3-ABA146F0933B}" dt="2024-02-07T10:02:15.146" v="148" actId="20577"/>
          <ac:spMkLst>
            <pc:docMk/>
            <pc:sldMk cId="505652439" sldId="379"/>
            <ac:spMk id="13" creationId="{665599A0-8E79-7029-3112-013819EE5B42}"/>
          </ac:spMkLst>
        </pc:spChg>
        <pc:spChg chg="add mod">
          <ac:chgData name="Vorsteveld, Emil" userId="bc0ba57b-6ec0-4081-81cf-a71345377d75" providerId="ADAL" clId="{02F4EAC6-C738-5143-B8E3-ABA146F0933B}" dt="2024-02-07T10:02:17.361" v="149" actId="20577"/>
          <ac:spMkLst>
            <pc:docMk/>
            <pc:sldMk cId="505652439" sldId="379"/>
            <ac:spMk id="14" creationId="{0F149D86-9BAB-872A-1EA5-E92D787939C3}"/>
          </ac:spMkLst>
        </pc:spChg>
        <pc:spChg chg="add mod">
          <ac:chgData name="Vorsteveld, Emil" userId="bc0ba57b-6ec0-4081-81cf-a71345377d75" providerId="ADAL" clId="{02F4EAC6-C738-5143-B8E3-ABA146F0933B}" dt="2024-02-07T10:02:20.006" v="150" actId="6549"/>
          <ac:spMkLst>
            <pc:docMk/>
            <pc:sldMk cId="505652439" sldId="379"/>
            <ac:spMk id="15" creationId="{9D7E57B4-5EF1-385C-E8C1-70F3425B62E6}"/>
          </ac:spMkLst>
        </pc:spChg>
        <pc:grpChg chg="add del mod">
          <ac:chgData name="Vorsteveld, Emil" userId="bc0ba57b-6ec0-4081-81cf-a71345377d75" providerId="ADAL" clId="{02F4EAC6-C738-5143-B8E3-ABA146F0933B}" dt="2024-02-07T09:59:06.025" v="107" actId="165"/>
          <ac:grpSpMkLst>
            <pc:docMk/>
            <pc:sldMk cId="505652439" sldId="379"/>
            <ac:grpSpMk id="5" creationId="{D126E2A7-100F-8F08-381E-EC631E4170C3}"/>
          </ac:grpSpMkLst>
        </pc:grpChg>
        <pc:grpChg chg="add mod">
          <ac:chgData name="Vorsteveld, Emil" userId="bc0ba57b-6ec0-4081-81cf-a71345377d75" providerId="ADAL" clId="{02F4EAC6-C738-5143-B8E3-ABA146F0933B}" dt="2024-02-09T12:23:59.907" v="228" actId="1076"/>
          <ac:grpSpMkLst>
            <pc:docMk/>
            <pc:sldMk cId="505652439" sldId="379"/>
            <ac:grpSpMk id="16" creationId="{F9F66C9F-EFE6-4D0C-7890-9C1DB62D3AA0}"/>
          </ac:grpSpMkLst>
        </pc:grpChg>
        <pc:grpChg chg="add mod">
          <ac:chgData name="Vorsteveld, Emil" userId="bc0ba57b-6ec0-4081-81cf-a71345377d75" providerId="ADAL" clId="{02F4EAC6-C738-5143-B8E3-ABA146F0933B}" dt="2024-02-09T12:23:59.907" v="228" actId="1076"/>
          <ac:grpSpMkLst>
            <pc:docMk/>
            <pc:sldMk cId="505652439" sldId="379"/>
            <ac:grpSpMk id="17" creationId="{3017451F-769C-D425-F938-948510D7D96E}"/>
          </ac:grpSpMkLst>
        </pc:grpChg>
        <pc:grpChg chg="add mod">
          <ac:chgData name="Vorsteveld, Emil" userId="bc0ba57b-6ec0-4081-81cf-a71345377d75" providerId="ADAL" clId="{02F4EAC6-C738-5143-B8E3-ABA146F0933B}" dt="2024-02-09T12:23:59.907" v="228" actId="1076"/>
          <ac:grpSpMkLst>
            <pc:docMk/>
            <pc:sldMk cId="505652439" sldId="379"/>
            <ac:grpSpMk id="18" creationId="{B8626FF2-2218-11F9-3FEA-1EDD5F37AC62}"/>
          </ac:grpSpMkLst>
        </pc:grpChg>
        <pc:grpChg chg="add del mod">
          <ac:chgData name="Vorsteveld, Emil" userId="bc0ba57b-6ec0-4081-81cf-a71345377d75" providerId="ADAL" clId="{02F4EAC6-C738-5143-B8E3-ABA146F0933B}" dt="2024-02-08T08:54:33.629" v="175" actId="21"/>
          <ac:grpSpMkLst>
            <pc:docMk/>
            <pc:sldMk cId="505652439" sldId="379"/>
            <ac:grpSpMk id="19" creationId="{C42EA08D-A083-47E2-2099-FE5FC95A0F73}"/>
          </ac:grpSpMkLst>
        </pc:grpChg>
        <pc:grpChg chg="add del">
          <ac:chgData name="Vorsteveld, Emil" userId="bc0ba57b-6ec0-4081-81cf-a71345377d75" providerId="ADAL" clId="{02F4EAC6-C738-5143-B8E3-ABA146F0933B}" dt="2024-02-08T08:54:33.629" v="175" actId="21"/>
          <ac:grpSpMkLst>
            <pc:docMk/>
            <pc:sldMk cId="505652439" sldId="379"/>
            <ac:grpSpMk id="20" creationId="{1CA8F795-DAB0-FE13-FDF8-9DAD195EA365}"/>
          </ac:grpSpMkLst>
        </pc:grpChg>
        <pc:grpChg chg="add del">
          <ac:chgData name="Vorsteveld, Emil" userId="bc0ba57b-6ec0-4081-81cf-a71345377d75" providerId="ADAL" clId="{02F4EAC6-C738-5143-B8E3-ABA146F0933B}" dt="2024-02-08T08:54:33.629" v="175" actId="21"/>
          <ac:grpSpMkLst>
            <pc:docMk/>
            <pc:sldMk cId="505652439" sldId="379"/>
            <ac:grpSpMk id="21" creationId="{C5895465-8EBE-16CC-6C78-0ED289C6E5D0}"/>
          </ac:grpSpMkLst>
        </pc:grpChg>
        <pc:picChg chg="mod">
          <ac:chgData name="Vorsteveld, Emil" userId="bc0ba57b-6ec0-4081-81cf-a71345377d75" providerId="ADAL" clId="{02F4EAC6-C738-5143-B8E3-ABA146F0933B}" dt="2024-02-07T10:00:23.066" v="127" actId="1076"/>
          <ac:picMkLst>
            <pc:docMk/>
            <pc:sldMk cId="505652439" sldId="379"/>
            <ac:picMk id="3" creationId="{A6DD35A9-6B42-42FA-7D4C-950B8DBDAC77}"/>
          </ac:picMkLst>
        </pc:picChg>
        <pc:picChg chg="mod">
          <ac:chgData name="Vorsteveld, Emil" userId="bc0ba57b-6ec0-4081-81cf-a71345377d75" providerId="ADAL" clId="{02F4EAC6-C738-5143-B8E3-ABA146F0933B}" dt="2024-02-07T10:00:23.066" v="127" actId="1076"/>
          <ac:picMkLst>
            <pc:docMk/>
            <pc:sldMk cId="505652439" sldId="379"/>
            <ac:picMk id="4" creationId="{804DE5EC-EE50-1A9B-A485-D12F542DA09D}"/>
          </ac:picMkLst>
        </pc:picChg>
        <pc:picChg chg="mod">
          <ac:chgData name="Vorsteveld, Emil" userId="bc0ba57b-6ec0-4081-81cf-a71345377d75" providerId="ADAL" clId="{02F4EAC6-C738-5143-B8E3-ABA146F0933B}" dt="2024-02-07T10:00:58.789" v="136" actId="1076"/>
          <ac:picMkLst>
            <pc:docMk/>
            <pc:sldMk cId="505652439" sldId="379"/>
            <ac:picMk id="6" creationId="{8D33AB4C-6F96-BF82-7741-8D1AFBD955FC}"/>
          </ac:picMkLst>
        </pc:picChg>
        <pc:picChg chg="mod topLvl modCrop">
          <ac:chgData name="Vorsteveld, Emil" userId="bc0ba57b-6ec0-4081-81cf-a71345377d75" providerId="ADAL" clId="{02F4EAC6-C738-5143-B8E3-ABA146F0933B}" dt="2024-02-07T10:03:23.597" v="165" actId="14100"/>
          <ac:picMkLst>
            <pc:docMk/>
            <pc:sldMk cId="505652439" sldId="379"/>
            <ac:picMk id="10" creationId="{1D67D4FF-7395-77CF-26CB-266BE6DF4973}"/>
          </ac:picMkLst>
        </pc:picChg>
        <pc:picChg chg="mod topLvl">
          <ac:chgData name="Vorsteveld, Emil" userId="bc0ba57b-6ec0-4081-81cf-a71345377d75" providerId="ADAL" clId="{02F4EAC6-C738-5143-B8E3-ABA146F0933B}" dt="2024-02-07T10:03:20.673" v="164" actId="14100"/>
          <ac:picMkLst>
            <pc:docMk/>
            <pc:sldMk cId="505652439" sldId="379"/>
            <ac:picMk id="11" creationId="{BE2ADECF-2858-AC23-CFA1-C099FED4738D}"/>
          </ac:picMkLst>
        </pc:picChg>
        <pc:picChg chg="mod topLvl">
          <ac:chgData name="Vorsteveld, Emil" userId="bc0ba57b-6ec0-4081-81cf-a71345377d75" providerId="ADAL" clId="{02F4EAC6-C738-5143-B8E3-ABA146F0933B}" dt="2024-02-07T10:00:38.881" v="132" actId="1076"/>
          <ac:picMkLst>
            <pc:docMk/>
            <pc:sldMk cId="505652439" sldId="379"/>
            <ac:picMk id="12" creationId="{FB9672BD-F3B2-8EBB-7897-427E266A7D44}"/>
          </ac:picMkLst>
        </pc:picChg>
      </pc:sldChg>
      <pc:sldChg chg="addSp delSp modSp add del mod modShow">
        <pc:chgData name="Vorsteveld, Emil" userId="bc0ba57b-6ec0-4081-81cf-a71345377d75" providerId="ADAL" clId="{02F4EAC6-C738-5143-B8E3-ABA146F0933B}" dt="2024-02-08T08:55:48.510" v="204" actId="2696"/>
        <pc:sldMkLst>
          <pc:docMk/>
          <pc:sldMk cId="1834300782" sldId="411"/>
        </pc:sldMkLst>
        <pc:spChg chg="mod">
          <ac:chgData name="Vorsteveld, Emil" userId="bc0ba57b-6ec0-4081-81cf-a71345377d75" providerId="ADAL" clId="{02F4EAC6-C738-5143-B8E3-ABA146F0933B}" dt="2024-02-05T15:50:00.547" v="89" actId="20577"/>
          <ac:spMkLst>
            <pc:docMk/>
            <pc:sldMk cId="1834300782" sldId="411"/>
            <ac:spMk id="2" creationId="{4A286EC3-5AF1-604E-4296-2332CEEC7658}"/>
          </ac:spMkLst>
        </pc:spChg>
        <pc:spChg chg="del">
          <ac:chgData name="Vorsteveld, Emil" userId="bc0ba57b-6ec0-4081-81cf-a71345377d75" providerId="ADAL" clId="{02F4EAC6-C738-5143-B8E3-ABA146F0933B}" dt="2024-02-05T11:04:56.191" v="5" actId="478"/>
          <ac:spMkLst>
            <pc:docMk/>
            <pc:sldMk cId="1834300782" sldId="411"/>
            <ac:spMk id="7" creationId="{B06080BF-2051-E7BF-F9CA-192F246DD5AA}"/>
          </ac:spMkLst>
        </pc:spChg>
        <pc:spChg chg="del">
          <ac:chgData name="Vorsteveld, Emil" userId="bc0ba57b-6ec0-4081-81cf-a71345377d75" providerId="ADAL" clId="{02F4EAC6-C738-5143-B8E3-ABA146F0933B}" dt="2024-02-05T11:04:57.827" v="6" actId="478"/>
          <ac:spMkLst>
            <pc:docMk/>
            <pc:sldMk cId="1834300782" sldId="411"/>
            <ac:spMk id="8" creationId="{7706B78E-2613-36FD-C128-C27DDDB8576E}"/>
          </ac:spMkLst>
        </pc:spChg>
        <pc:spChg chg="add mod">
          <ac:chgData name="Vorsteveld, Emil" userId="bc0ba57b-6ec0-4081-81cf-a71345377d75" providerId="ADAL" clId="{02F4EAC6-C738-5143-B8E3-ABA146F0933B}" dt="2024-02-05T15:50:06.064" v="90" actId="1076"/>
          <ac:spMkLst>
            <pc:docMk/>
            <pc:sldMk cId="1834300782" sldId="411"/>
            <ac:spMk id="17" creationId="{94E74BF4-B640-179E-1213-265650A51AE0}"/>
          </ac:spMkLst>
        </pc:spChg>
        <pc:spChg chg="add mod">
          <ac:chgData name="Vorsteveld, Emil" userId="bc0ba57b-6ec0-4081-81cf-a71345377d75" providerId="ADAL" clId="{02F4EAC6-C738-5143-B8E3-ABA146F0933B}" dt="2024-02-05T15:50:06.064" v="90" actId="1076"/>
          <ac:spMkLst>
            <pc:docMk/>
            <pc:sldMk cId="1834300782" sldId="411"/>
            <ac:spMk id="18" creationId="{509D6FCC-1814-3A1B-C193-43C98011C974}"/>
          </ac:spMkLst>
        </pc:spChg>
        <pc:spChg chg="add mod">
          <ac:chgData name="Vorsteveld, Emil" userId="bc0ba57b-6ec0-4081-81cf-a71345377d75" providerId="ADAL" clId="{02F4EAC6-C738-5143-B8E3-ABA146F0933B}" dt="2024-02-05T15:50:06.064" v="90" actId="1076"/>
          <ac:spMkLst>
            <pc:docMk/>
            <pc:sldMk cId="1834300782" sldId="411"/>
            <ac:spMk id="19" creationId="{33CEB688-F786-DA26-C7D2-C1F8436DEC7A}"/>
          </ac:spMkLst>
        </pc:spChg>
        <pc:spChg chg="add del mod">
          <ac:chgData name="Vorsteveld, Emil" userId="bc0ba57b-6ec0-4081-81cf-a71345377d75" providerId="ADAL" clId="{02F4EAC6-C738-5143-B8E3-ABA146F0933B}" dt="2024-02-06T16:30:22.456" v="103" actId="478"/>
          <ac:spMkLst>
            <pc:docMk/>
            <pc:sldMk cId="1834300782" sldId="411"/>
            <ac:spMk id="20" creationId="{1F54852F-FC99-7C94-8E5D-8D76F89FBFE1}"/>
          </ac:spMkLst>
        </pc:spChg>
        <pc:grpChg chg="add mod">
          <ac:chgData name="Vorsteveld, Emil" userId="bc0ba57b-6ec0-4081-81cf-a71345377d75" providerId="ADAL" clId="{02F4EAC6-C738-5143-B8E3-ABA146F0933B}" dt="2024-02-05T15:50:06.064" v="90" actId="1076"/>
          <ac:grpSpMkLst>
            <pc:docMk/>
            <pc:sldMk cId="1834300782" sldId="411"/>
            <ac:grpSpMk id="16" creationId="{3F3A8FCA-C4E1-687E-8AB3-9D9774A0BA8A}"/>
          </ac:grpSpMkLst>
        </pc:grpChg>
        <pc:picChg chg="add mod">
          <ac:chgData name="Vorsteveld, Emil" userId="bc0ba57b-6ec0-4081-81cf-a71345377d75" providerId="ADAL" clId="{02F4EAC6-C738-5143-B8E3-ABA146F0933B}" dt="2024-02-05T15:47:46.369" v="75" actId="14100"/>
          <ac:picMkLst>
            <pc:docMk/>
            <pc:sldMk cId="1834300782" sldId="411"/>
            <ac:picMk id="4" creationId="{B28410B8-986F-B375-9F9B-1E5853BD7D22}"/>
          </ac:picMkLst>
        </pc:picChg>
        <pc:picChg chg="add mod modCrop">
          <ac:chgData name="Vorsteveld, Emil" userId="bc0ba57b-6ec0-4081-81cf-a71345377d75" providerId="ADAL" clId="{02F4EAC6-C738-5143-B8E3-ABA146F0933B}" dt="2024-02-05T15:47:46.369" v="75" actId="14100"/>
          <ac:picMkLst>
            <pc:docMk/>
            <pc:sldMk cId="1834300782" sldId="411"/>
            <ac:picMk id="6" creationId="{512538F8-4F01-A151-2C3A-195869752207}"/>
          </ac:picMkLst>
        </pc:picChg>
        <pc:picChg chg="del">
          <ac:chgData name="Vorsteveld, Emil" userId="bc0ba57b-6ec0-4081-81cf-a71345377d75" providerId="ADAL" clId="{02F4EAC6-C738-5143-B8E3-ABA146F0933B}" dt="2024-02-05T11:04:54.424" v="3" actId="478"/>
          <ac:picMkLst>
            <pc:docMk/>
            <pc:sldMk cId="1834300782" sldId="411"/>
            <ac:picMk id="9" creationId="{A6AE6FDE-A48E-F6EC-1490-06933D896FD7}"/>
          </ac:picMkLst>
        </pc:picChg>
        <pc:picChg chg="del">
          <ac:chgData name="Vorsteveld, Emil" userId="bc0ba57b-6ec0-4081-81cf-a71345377d75" providerId="ADAL" clId="{02F4EAC6-C738-5143-B8E3-ABA146F0933B}" dt="2024-02-05T11:04:54.842" v="4" actId="478"/>
          <ac:picMkLst>
            <pc:docMk/>
            <pc:sldMk cId="1834300782" sldId="411"/>
            <ac:picMk id="10" creationId="{ADD0C43D-DB81-910F-F4F7-BB84008EE1ED}"/>
          </ac:picMkLst>
        </pc:picChg>
        <pc:picChg chg="del">
          <ac:chgData name="Vorsteveld, Emil" userId="bc0ba57b-6ec0-4081-81cf-a71345377d75" providerId="ADAL" clId="{02F4EAC6-C738-5143-B8E3-ABA146F0933B}" dt="2024-02-05T11:04:58.266" v="7" actId="478"/>
          <ac:picMkLst>
            <pc:docMk/>
            <pc:sldMk cId="1834300782" sldId="411"/>
            <ac:picMk id="11" creationId="{C7E9035F-2545-8628-E137-50E6060FE8CD}"/>
          </ac:picMkLst>
        </pc:picChg>
        <pc:picChg chg="add del mod">
          <ac:chgData name="Vorsteveld, Emil" userId="bc0ba57b-6ec0-4081-81cf-a71345377d75" providerId="ADAL" clId="{02F4EAC6-C738-5143-B8E3-ABA146F0933B}" dt="2024-02-05T15:45:52.877" v="54" actId="478"/>
          <ac:picMkLst>
            <pc:docMk/>
            <pc:sldMk cId="1834300782" sldId="411"/>
            <ac:picMk id="12" creationId="{227182DC-1C48-FC33-8877-AD836ACACB94}"/>
          </ac:picMkLst>
        </pc:picChg>
        <pc:picChg chg="add del mod">
          <ac:chgData name="Vorsteveld, Emil" userId="bc0ba57b-6ec0-4081-81cf-a71345377d75" providerId="ADAL" clId="{02F4EAC6-C738-5143-B8E3-ABA146F0933B}" dt="2024-02-05T15:47:01.035" v="61" actId="478"/>
          <ac:picMkLst>
            <pc:docMk/>
            <pc:sldMk cId="1834300782" sldId="411"/>
            <ac:picMk id="13" creationId="{4AEB899D-59E8-D171-09F9-746FE0B395A8}"/>
          </ac:picMkLst>
        </pc:picChg>
        <pc:picChg chg="add del">
          <ac:chgData name="Vorsteveld, Emil" userId="bc0ba57b-6ec0-4081-81cf-a71345377d75" providerId="ADAL" clId="{02F4EAC6-C738-5143-B8E3-ABA146F0933B}" dt="2024-02-05T15:46:55.216" v="59" actId="478"/>
          <ac:picMkLst>
            <pc:docMk/>
            <pc:sldMk cId="1834300782" sldId="411"/>
            <ac:picMk id="14" creationId="{19564FC5-9532-1B55-3186-B86C96D31289}"/>
          </ac:picMkLst>
        </pc:picChg>
        <pc:picChg chg="add mod">
          <ac:chgData name="Vorsteveld, Emil" userId="bc0ba57b-6ec0-4081-81cf-a71345377d75" providerId="ADAL" clId="{02F4EAC6-C738-5143-B8E3-ABA146F0933B}" dt="2024-02-05T15:47:46.369" v="75" actId="14100"/>
          <ac:picMkLst>
            <pc:docMk/>
            <pc:sldMk cId="1834300782" sldId="411"/>
            <ac:picMk id="15" creationId="{8011D384-C472-F043-C6BF-0A0BA0E0D9A0}"/>
          </ac:picMkLst>
        </pc:picChg>
      </pc:sldChg>
      <pc:sldChg chg="new del">
        <pc:chgData name="Vorsteveld, Emil" userId="bc0ba57b-6ec0-4081-81cf-a71345377d75" providerId="ADAL" clId="{02F4EAC6-C738-5143-B8E3-ABA146F0933B}" dt="2024-02-05T11:04:52.300" v="1" actId="680"/>
        <pc:sldMkLst>
          <pc:docMk/>
          <pc:sldMk cId="4186482327" sldId="411"/>
        </pc:sldMkLst>
      </pc:sldChg>
      <pc:sldChg chg="addSp delSp modSp add mod modShow">
        <pc:chgData name="Vorsteveld, Emil" userId="bc0ba57b-6ec0-4081-81cf-a71345377d75" providerId="ADAL" clId="{02F4EAC6-C738-5143-B8E3-ABA146F0933B}" dt="2024-02-12T09:24:05.710" v="246" actId="729"/>
        <pc:sldMkLst>
          <pc:docMk/>
          <pc:sldMk cId="3837009971" sldId="412"/>
        </pc:sldMkLst>
        <pc:spChg chg="mod">
          <ac:chgData name="Vorsteveld, Emil" userId="bc0ba57b-6ec0-4081-81cf-a71345377d75" providerId="ADAL" clId="{02F4EAC6-C738-5143-B8E3-ABA146F0933B}" dt="2024-02-08T08:55:23.150" v="197" actId="20577"/>
          <ac:spMkLst>
            <pc:docMk/>
            <pc:sldMk cId="3837009971" sldId="412"/>
            <ac:spMk id="2" creationId="{DD990F44-6937-6B48-8615-B6700E069441}"/>
          </ac:spMkLst>
        </pc:spChg>
        <pc:spChg chg="del">
          <ac:chgData name="Vorsteveld, Emil" userId="bc0ba57b-6ec0-4081-81cf-a71345377d75" providerId="ADAL" clId="{02F4EAC6-C738-5143-B8E3-ABA146F0933B}" dt="2024-02-08T08:54:43.793" v="179" actId="478"/>
          <ac:spMkLst>
            <pc:docMk/>
            <pc:sldMk cId="3837009971" sldId="412"/>
            <ac:spMk id="3" creationId="{3329794D-F027-EBB3-4B3A-A7219E531D3C}"/>
          </ac:spMkLst>
        </pc:spChg>
        <pc:spChg chg="del">
          <ac:chgData name="Vorsteveld, Emil" userId="bc0ba57b-6ec0-4081-81cf-a71345377d75" providerId="ADAL" clId="{02F4EAC6-C738-5143-B8E3-ABA146F0933B}" dt="2024-02-08T08:54:44.962" v="180" actId="478"/>
          <ac:spMkLst>
            <pc:docMk/>
            <pc:sldMk cId="3837009971" sldId="412"/>
            <ac:spMk id="4" creationId="{364DFD38-983B-4FBA-BE3C-81A7E31E4681}"/>
          </ac:spMkLst>
        </pc:spChg>
        <pc:spChg chg="mod">
          <ac:chgData name="Vorsteveld, Emil" userId="bc0ba57b-6ec0-4081-81cf-a71345377d75" providerId="ADAL" clId="{02F4EAC6-C738-5143-B8E3-ABA146F0933B}" dt="2024-02-08T08:54:45.728" v="181"/>
          <ac:spMkLst>
            <pc:docMk/>
            <pc:sldMk cId="3837009971" sldId="412"/>
            <ac:spMk id="7" creationId="{2B545B8C-EF2C-EDB8-B7DA-7ECBC3C75B2C}"/>
          </ac:spMkLst>
        </pc:spChg>
        <pc:spChg chg="mod">
          <ac:chgData name="Vorsteveld, Emil" userId="bc0ba57b-6ec0-4081-81cf-a71345377d75" providerId="ADAL" clId="{02F4EAC6-C738-5143-B8E3-ABA146F0933B}" dt="2024-02-08T08:54:45.728" v="181"/>
          <ac:spMkLst>
            <pc:docMk/>
            <pc:sldMk cId="3837009971" sldId="412"/>
            <ac:spMk id="10" creationId="{E93CE006-B037-AEEA-D17F-5B1BF922013D}"/>
          </ac:spMkLst>
        </pc:spChg>
        <pc:spChg chg="add del mod topLvl">
          <ac:chgData name="Vorsteveld, Emil" userId="bc0ba57b-6ec0-4081-81cf-a71345377d75" providerId="ADAL" clId="{02F4EAC6-C738-5143-B8E3-ABA146F0933B}" dt="2024-02-08T11:01:33.765" v="210" actId="478"/>
          <ac:spMkLst>
            <pc:docMk/>
            <pc:sldMk cId="3837009971" sldId="412"/>
            <ac:spMk id="13" creationId="{31482FD2-B5EA-BF44-97A1-99FD8D88DB7D}"/>
          </ac:spMkLst>
        </pc:spChg>
        <pc:spChg chg="add del mod">
          <ac:chgData name="Vorsteveld, Emil" userId="bc0ba57b-6ec0-4081-81cf-a71345377d75" providerId="ADAL" clId="{02F4EAC6-C738-5143-B8E3-ABA146F0933B}" dt="2024-02-08T08:55:20.528" v="195"/>
          <ac:spMkLst>
            <pc:docMk/>
            <pc:sldMk cId="3837009971" sldId="412"/>
            <ac:spMk id="14" creationId="{1D628813-AFA9-07A5-E1EE-C7A994E7AEF6}"/>
          </ac:spMkLst>
        </pc:spChg>
        <pc:grpChg chg="add del mod">
          <ac:chgData name="Vorsteveld, Emil" userId="bc0ba57b-6ec0-4081-81cf-a71345377d75" providerId="ADAL" clId="{02F4EAC6-C738-5143-B8E3-ABA146F0933B}" dt="2024-02-12T09:23:25.126" v="235" actId="478"/>
          <ac:grpSpMkLst>
            <pc:docMk/>
            <pc:sldMk cId="3837009971" sldId="412"/>
            <ac:grpSpMk id="5" creationId="{ABD1D7F0-62EB-9643-1319-6E0965FAD0BF}"/>
          </ac:grpSpMkLst>
        </pc:grpChg>
        <pc:grpChg chg="add del mod">
          <ac:chgData name="Vorsteveld, Emil" userId="bc0ba57b-6ec0-4081-81cf-a71345377d75" providerId="ADAL" clId="{02F4EAC6-C738-5143-B8E3-ABA146F0933B}" dt="2024-02-12T09:23:25.601" v="236" actId="478"/>
          <ac:grpSpMkLst>
            <pc:docMk/>
            <pc:sldMk cId="3837009971" sldId="412"/>
            <ac:grpSpMk id="8" creationId="{0A4A7409-711D-C1E3-E8E7-1D3E2793F02D}"/>
          </ac:grpSpMkLst>
        </pc:grpChg>
        <pc:grpChg chg="add del mod">
          <ac:chgData name="Vorsteveld, Emil" userId="bc0ba57b-6ec0-4081-81cf-a71345377d75" providerId="ADAL" clId="{02F4EAC6-C738-5143-B8E3-ABA146F0933B}" dt="2024-02-12T09:23:26.021" v="237" actId="478"/>
          <ac:grpSpMkLst>
            <pc:docMk/>
            <pc:sldMk cId="3837009971" sldId="412"/>
            <ac:grpSpMk id="11" creationId="{AE01D4F6-1738-978D-8CEC-FAA038137C0C}"/>
          </ac:grpSpMkLst>
        </pc:grpChg>
        <pc:picChg chg="mod">
          <ac:chgData name="Vorsteveld, Emil" userId="bc0ba57b-6ec0-4081-81cf-a71345377d75" providerId="ADAL" clId="{02F4EAC6-C738-5143-B8E3-ABA146F0933B}" dt="2024-02-08T08:54:45.728" v="181"/>
          <ac:picMkLst>
            <pc:docMk/>
            <pc:sldMk cId="3837009971" sldId="412"/>
            <ac:picMk id="6" creationId="{A9EC8F27-A29C-B8B5-537C-C76F626DFFBE}"/>
          </ac:picMkLst>
        </pc:picChg>
        <pc:picChg chg="mod">
          <ac:chgData name="Vorsteveld, Emil" userId="bc0ba57b-6ec0-4081-81cf-a71345377d75" providerId="ADAL" clId="{02F4EAC6-C738-5143-B8E3-ABA146F0933B}" dt="2024-02-08T08:54:45.728" v="181"/>
          <ac:picMkLst>
            <pc:docMk/>
            <pc:sldMk cId="3837009971" sldId="412"/>
            <ac:picMk id="9" creationId="{95A5C5DF-9B7F-AE7E-1E2F-3918459C1A41}"/>
          </ac:picMkLst>
        </pc:picChg>
        <pc:picChg chg="add del mod topLvl">
          <ac:chgData name="Vorsteveld, Emil" userId="bc0ba57b-6ec0-4081-81cf-a71345377d75" providerId="ADAL" clId="{02F4EAC6-C738-5143-B8E3-ABA146F0933B}" dt="2024-02-08T11:01:33.765" v="210" actId="478"/>
          <ac:picMkLst>
            <pc:docMk/>
            <pc:sldMk cId="3837009971" sldId="412"/>
            <ac:picMk id="12" creationId="{AE2CA21F-BDD6-4209-ED74-49ADE22D601F}"/>
          </ac:picMkLst>
        </pc:picChg>
        <pc:picChg chg="del">
          <ac:chgData name="Vorsteveld, Emil" userId="bc0ba57b-6ec0-4081-81cf-a71345377d75" providerId="ADAL" clId="{02F4EAC6-C738-5143-B8E3-ABA146F0933B}" dt="2024-02-08T08:54:41.961" v="177" actId="478"/>
          <ac:picMkLst>
            <pc:docMk/>
            <pc:sldMk cId="3837009971" sldId="412"/>
            <ac:picMk id="15" creationId="{B3E6B335-D475-C786-8A20-D59C00ECB790}"/>
          </ac:picMkLst>
        </pc:picChg>
        <pc:picChg chg="del">
          <ac:chgData name="Vorsteveld, Emil" userId="bc0ba57b-6ec0-4081-81cf-a71345377d75" providerId="ADAL" clId="{02F4EAC6-C738-5143-B8E3-ABA146F0933B}" dt="2024-02-08T08:54:42.291" v="178" actId="478"/>
          <ac:picMkLst>
            <pc:docMk/>
            <pc:sldMk cId="3837009971" sldId="412"/>
            <ac:picMk id="17" creationId="{39D57498-8872-4395-DA47-18826D06B9AE}"/>
          </ac:picMkLst>
        </pc:picChg>
        <pc:picChg chg="add mod">
          <ac:chgData name="Vorsteveld, Emil" userId="bc0ba57b-6ec0-4081-81cf-a71345377d75" providerId="ADAL" clId="{02F4EAC6-C738-5143-B8E3-ABA146F0933B}" dt="2024-02-12T09:24:01.119" v="244" actId="14100"/>
          <ac:picMkLst>
            <pc:docMk/>
            <pc:sldMk cId="3837009971" sldId="412"/>
            <ac:picMk id="18" creationId="{99E2363C-D59B-7C07-F595-983E56BEC54D}"/>
          </ac:picMkLst>
        </pc:picChg>
      </pc:sldChg>
      <pc:sldChg chg="addSp delSp modSp add del mod">
        <pc:chgData name="Vorsteveld, Emil" userId="bc0ba57b-6ec0-4081-81cf-a71345377d75" providerId="ADAL" clId="{02F4EAC6-C738-5143-B8E3-ABA146F0933B}" dt="2024-02-14T12:13:21.550" v="286" actId="2696"/>
        <pc:sldMkLst>
          <pc:docMk/>
          <pc:sldMk cId="3447572227" sldId="413"/>
        </pc:sldMkLst>
        <pc:grpChg chg="del">
          <ac:chgData name="Vorsteveld, Emil" userId="bc0ba57b-6ec0-4081-81cf-a71345377d75" providerId="ADAL" clId="{02F4EAC6-C738-5143-B8E3-ABA146F0933B}" dt="2024-02-08T11:01:40.502" v="214" actId="478"/>
          <ac:grpSpMkLst>
            <pc:docMk/>
            <pc:sldMk cId="3447572227" sldId="413"/>
            <ac:grpSpMk id="5" creationId="{ABD1D7F0-62EB-9643-1319-6E0965FAD0BF}"/>
          </ac:grpSpMkLst>
        </pc:grpChg>
        <pc:grpChg chg="del">
          <ac:chgData name="Vorsteveld, Emil" userId="bc0ba57b-6ec0-4081-81cf-a71345377d75" providerId="ADAL" clId="{02F4EAC6-C738-5143-B8E3-ABA146F0933B}" dt="2024-02-08T11:01:41.522" v="215" actId="478"/>
          <ac:grpSpMkLst>
            <pc:docMk/>
            <pc:sldMk cId="3447572227" sldId="413"/>
            <ac:grpSpMk id="8" creationId="{0A4A7409-711D-C1E3-E8E7-1D3E2793F02D}"/>
          </ac:grpSpMkLst>
        </pc:grpChg>
        <pc:grpChg chg="del">
          <ac:chgData name="Vorsteveld, Emil" userId="bc0ba57b-6ec0-4081-81cf-a71345377d75" providerId="ADAL" clId="{02F4EAC6-C738-5143-B8E3-ABA146F0933B}" dt="2024-02-08T11:01:41.940" v="216" actId="478"/>
          <ac:grpSpMkLst>
            <pc:docMk/>
            <pc:sldMk cId="3447572227" sldId="413"/>
            <ac:grpSpMk id="11" creationId="{AE01D4F6-1738-978D-8CEC-FAA038137C0C}"/>
          </ac:grpSpMkLst>
        </pc:grpChg>
        <pc:picChg chg="add del mod">
          <ac:chgData name="Vorsteveld, Emil" userId="bc0ba57b-6ec0-4081-81cf-a71345377d75" providerId="ADAL" clId="{02F4EAC6-C738-5143-B8E3-ABA146F0933B}" dt="2024-02-08T11:17:18.998" v="222" actId="478"/>
          <ac:picMkLst>
            <pc:docMk/>
            <pc:sldMk cId="3447572227" sldId="413"/>
            <ac:picMk id="4" creationId="{C796DEAE-C638-40BE-EEF2-1D978F573A0F}"/>
          </ac:picMkLst>
        </pc:picChg>
        <pc:picChg chg="add mod">
          <ac:chgData name="Vorsteveld, Emil" userId="bc0ba57b-6ec0-4081-81cf-a71345377d75" providerId="ADAL" clId="{02F4EAC6-C738-5143-B8E3-ABA146F0933B}" dt="2024-02-08T11:18:00.722" v="227" actId="14100"/>
          <ac:picMkLst>
            <pc:docMk/>
            <pc:sldMk cId="3447572227" sldId="413"/>
            <ac:picMk id="15" creationId="{C8BB72A5-3B37-94A1-BF37-C7A20A236CF2}"/>
          </ac:picMkLst>
        </pc:picChg>
      </pc:sldChg>
      <pc:sldChg chg="addSp delSp modSp add del mod">
        <pc:chgData name="Vorsteveld, Emil" userId="bc0ba57b-6ec0-4081-81cf-a71345377d75" providerId="ADAL" clId="{02F4EAC6-C738-5143-B8E3-ABA146F0933B}" dt="2024-02-14T12:13:12.763" v="285" actId="2696"/>
        <pc:sldMkLst>
          <pc:docMk/>
          <pc:sldMk cId="938187052" sldId="414"/>
        </pc:sldMkLst>
        <pc:spChg chg="add del mod">
          <ac:chgData name="Vorsteveld, Emil" userId="bc0ba57b-6ec0-4081-81cf-a71345377d75" providerId="ADAL" clId="{02F4EAC6-C738-5143-B8E3-ABA146F0933B}" dt="2024-02-14T12:13:09.458" v="283" actId="478"/>
          <ac:spMkLst>
            <pc:docMk/>
            <pc:sldMk cId="938187052" sldId="414"/>
            <ac:spMk id="3" creationId="{15C13B68-477C-5466-19C0-CEFFDCBC4602}"/>
          </ac:spMkLst>
        </pc:spChg>
        <pc:spChg chg="add del mod">
          <ac:chgData name="Vorsteveld, Emil" userId="bc0ba57b-6ec0-4081-81cf-a71345377d75" providerId="ADAL" clId="{02F4EAC6-C738-5143-B8E3-ABA146F0933B}" dt="2024-02-14T12:13:10.604" v="284" actId="478"/>
          <ac:spMkLst>
            <pc:docMk/>
            <pc:sldMk cId="938187052" sldId="414"/>
            <ac:spMk id="5" creationId="{B8EF6A08-8EBC-8B72-8CCD-3C105C6CC00C}"/>
          </ac:spMkLst>
        </pc:spChg>
        <pc:picChg chg="add mod">
          <ac:chgData name="Vorsteveld, Emil" userId="bc0ba57b-6ec0-4081-81cf-a71345377d75" providerId="ADAL" clId="{02F4EAC6-C738-5143-B8E3-ABA146F0933B}" dt="2024-02-12T16:12:15.806" v="258" actId="571"/>
          <ac:picMkLst>
            <pc:docMk/>
            <pc:sldMk cId="938187052" sldId="414"/>
            <ac:picMk id="4" creationId="{1A25D0EB-C834-8E59-2BFE-60FF05BDB62B}"/>
          </ac:picMkLst>
        </pc:picChg>
      </pc:sldChg>
      <pc:sldChg chg="add del">
        <pc:chgData name="Vorsteveld, Emil" userId="bc0ba57b-6ec0-4081-81cf-a71345377d75" providerId="ADAL" clId="{02F4EAC6-C738-5143-B8E3-ABA146F0933B}" dt="2024-02-12T09:24:03.351" v="245" actId="2696"/>
        <pc:sldMkLst>
          <pc:docMk/>
          <pc:sldMk cId="3850719640" sldId="41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0694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20210096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15378570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298150377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233889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138F32E2-9CB5-2F39-8640-F4C46CCF3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0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0C576A5-617A-83ED-C591-B1707E0900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0" y="863549"/>
            <a:ext cx="3017468" cy="341640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01D7489-87C5-E682-D4F4-46BAB672F6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5620" y="863549"/>
            <a:ext cx="3017468" cy="3416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34676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FFFC56-6961-9EA7-723B-6C6F87A24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1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FC66ABC-1885-2E2C-91C9-00BB90153A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2547" y="1201207"/>
            <a:ext cx="2284889" cy="18903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977BCBF-ECD3-B525-EACD-4000787A79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18346" y="1201207"/>
            <a:ext cx="2284889" cy="19463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8174BC4-400F-63E6-3E66-C347DAA437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700" y="1308560"/>
            <a:ext cx="3406646" cy="17876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D743D87-DF23-95ED-454E-7E2EDCE8934F}"/>
              </a:ext>
            </a:extLst>
          </p:cNvPr>
          <p:cNvSpPr txBox="1"/>
          <p:nvPr/>
        </p:nvSpPr>
        <p:spPr>
          <a:xfrm>
            <a:off x="311700" y="1100380"/>
            <a:ext cx="478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77B6A7-D129-F494-E4DF-C15AF47DE637}"/>
              </a:ext>
            </a:extLst>
          </p:cNvPr>
          <p:cNvSpPr txBox="1"/>
          <p:nvPr/>
        </p:nvSpPr>
        <p:spPr>
          <a:xfrm>
            <a:off x="3729077" y="1100380"/>
            <a:ext cx="478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DDAA5C-F1E3-EDEB-9CDA-747EBE1E50FE}"/>
              </a:ext>
            </a:extLst>
          </p:cNvPr>
          <p:cNvSpPr txBox="1"/>
          <p:nvPr/>
        </p:nvSpPr>
        <p:spPr>
          <a:xfrm>
            <a:off x="5914338" y="1100380"/>
            <a:ext cx="478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021375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FA9C3-B82D-D66E-ADDE-2424EE080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-33854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1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29A0EDD-1A89-7512-1674-B54041EC8D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0361" y="763500"/>
            <a:ext cx="3403651" cy="22229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AE88A48-E32D-CDB1-27F3-93A53EFB1E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1844" y="763499"/>
            <a:ext cx="3403652" cy="222299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7B1A0BE-7594-E5F5-FFDD-A9CBCF162D23}"/>
              </a:ext>
            </a:extLst>
          </p:cNvPr>
          <p:cNvSpPr txBox="1"/>
          <p:nvPr/>
        </p:nvSpPr>
        <p:spPr>
          <a:xfrm>
            <a:off x="849791" y="763499"/>
            <a:ext cx="478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683A3B-5EF3-FCC3-4D3C-4D7843658FCA}"/>
              </a:ext>
            </a:extLst>
          </p:cNvPr>
          <p:cNvSpPr txBox="1"/>
          <p:nvPr/>
        </p:nvSpPr>
        <p:spPr>
          <a:xfrm>
            <a:off x="4267168" y="763499"/>
            <a:ext cx="478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526658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86EC3-5AF1-604E-4296-2332CEEC7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24612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1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6080BF-2051-E7BF-F9CA-192F246DD5AA}"/>
              </a:ext>
            </a:extLst>
          </p:cNvPr>
          <p:cNvSpPr txBox="1"/>
          <p:nvPr/>
        </p:nvSpPr>
        <p:spPr>
          <a:xfrm>
            <a:off x="891082" y="554292"/>
            <a:ext cx="540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 dirty="0"/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06B78E-2613-36FD-C128-C27DDDB8576E}"/>
              </a:ext>
            </a:extLst>
          </p:cNvPr>
          <p:cNvSpPr txBox="1"/>
          <p:nvPr/>
        </p:nvSpPr>
        <p:spPr>
          <a:xfrm>
            <a:off x="3714756" y="554293"/>
            <a:ext cx="540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/>
              <a:t>B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7E9035F-2545-8628-E137-50E6060FE8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5638" y="552158"/>
            <a:ext cx="4148304" cy="385267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0CCD018-13B2-D9C4-F891-477D5AD16F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1082" y="862069"/>
            <a:ext cx="2814116" cy="2814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3773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F00A1-E897-9457-AA1B-FD354F47E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159026"/>
            <a:ext cx="6645691" cy="515028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F4BAC9C-94A9-A299-6273-4016244CC5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3799" y="1068129"/>
            <a:ext cx="1826166" cy="30337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D9C481B-D71E-4D12-CF71-BBB85DDC77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0450" y="1179444"/>
            <a:ext cx="1823743" cy="239067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1744620-807D-159A-12FC-A633798B7109}"/>
              </a:ext>
            </a:extLst>
          </p:cNvPr>
          <p:cNvSpPr txBox="1"/>
          <p:nvPr/>
        </p:nvSpPr>
        <p:spPr>
          <a:xfrm>
            <a:off x="2228907" y="88773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B648B6A-7085-C5D9-0A79-68DD537749E8}"/>
              </a:ext>
            </a:extLst>
          </p:cNvPr>
          <p:cNvSpPr txBox="1"/>
          <p:nvPr/>
        </p:nvSpPr>
        <p:spPr>
          <a:xfrm>
            <a:off x="4631591" y="887736"/>
            <a:ext cx="304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89440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2EC2135-59D7-53AD-3CD3-C4B873121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0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14B5F03-9BC5-21B8-4D50-BA4DDE5D4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0692" y="1514030"/>
            <a:ext cx="3600828" cy="211543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073D580-3C77-6AD4-4655-5075624F95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9332" y="1400752"/>
            <a:ext cx="3886200" cy="24807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AA1E68C-6ED7-298A-1EAF-585A9050BDBF}"/>
              </a:ext>
            </a:extLst>
          </p:cNvPr>
          <p:cNvSpPr txBox="1"/>
          <p:nvPr/>
        </p:nvSpPr>
        <p:spPr>
          <a:xfrm>
            <a:off x="737678" y="126920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8DE54F-EDF3-887D-5A39-B96306951C58}"/>
              </a:ext>
            </a:extLst>
          </p:cNvPr>
          <p:cNvSpPr txBox="1"/>
          <p:nvPr/>
        </p:nvSpPr>
        <p:spPr>
          <a:xfrm>
            <a:off x="4572000" y="1269206"/>
            <a:ext cx="304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23690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6F37E-58A9-2A2C-F797-7F055999A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014" y="-215466"/>
            <a:ext cx="4155104" cy="755700"/>
          </a:xfrm>
        </p:spPr>
        <p:txBody>
          <a:bodyPr/>
          <a:lstStyle/>
          <a:p>
            <a:r>
              <a:rPr lang="en-NL" dirty="0"/>
              <a:t>Supplemental figure 4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7A0758B-AAE0-1225-512A-E8DDBBB44A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9801" y="937255"/>
            <a:ext cx="2844800" cy="28448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2F9ED48-72C7-588D-0148-B86614C014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724" y="938007"/>
            <a:ext cx="2844800" cy="2844800"/>
          </a:xfrm>
          <a:prstGeom prst="rect">
            <a:avLst/>
          </a:prstGeom>
        </p:spPr>
      </p:pic>
      <p:sp>
        <p:nvSpPr>
          <p:cNvPr id="14" name="Google Shape;116;p21">
            <a:extLst>
              <a:ext uri="{FF2B5EF4-FFF2-40B4-BE49-F238E27FC236}">
                <a16:creationId xmlns:a16="http://schemas.microsoft.com/office/drawing/2014/main" id="{1187E167-7631-E249-6CAE-2269B47E5667}"/>
              </a:ext>
            </a:extLst>
          </p:cNvPr>
          <p:cNvSpPr txBox="1"/>
          <p:nvPr/>
        </p:nvSpPr>
        <p:spPr>
          <a:xfrm>
            <a:off x="1493724" y="1080115"/>
            <a:ext cx="5181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A</a:t>
            </a:r>
            <a:endParaRPr/>
          </a:p>
        </p:txBody>
      </p:sp>
      <p:sp>
        <p:nvSpPr>
          <p:cNvPr id="15" name="Google Shape;117;p21">
            <a:extLst>
              <a:ext uri="{FF2B5EF4-FFF2-40B4-BE49-F238E27FC236}">
                <a16:creationId xmlns:a16="http://schemas.microsoft.com/office/drawing/2014/main" id="{47E3C760-4313-07F3-014E-9AF5C4B6CA45}"/>
              </a:ext>
            </a:extLst>
          </p:cNvPr>
          <p:cNvSpPr txBox="1"/>
          <p:nvPr/>
        </p:nvSpPr>
        <p:spPr>
          <a:xfrm>
            <a:off x="4572000" y="1080115"/>
            <a:ext cx="4365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B</a:t>
            </a:r>
            <a:endParaRPr/>
          </a:p>
        </p:txBody>
      </p:sp>
    </p:spTree>
    <p:extLst>
      <p:ext uri="{BB962C8B-B14F-4D97-AF65-F5344CB8AC3E}">
        <p14:creationId xmlns:p14="http://schemas.microsoft.com/office/powerpoint/2010/main" val="3910950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1D004A7C-7E96-1C35-76AF-173E8D631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194277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5</a:t>
            </a:r>
          </a:p>
        </p:txBody>
      </p:sp>
      <p:pic>
        <p:nvPicPr>
          <p:cNvPr id="6" name="Picture 5" descr="A picture containing text, screenshot, square, rectangle&#10;&#10;Description automatically generated">
            <a:extLst>
              <a:ext uri="{FF2B5EF4-FFF2-40B4-BE49-F238E27FC236}">
                <a16:creationId xmlns:a16="http://schemas.microsoft.com/office/drawing/2014/main" id="{9C3C21D3-6123-7F2F-E765-850FDD87E7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1357" y="874659"/>
            <a:ext cx="3032643" cy="2729379"/>
          </a:xfrm>
          <a:prstGeom prst="rect">
            <a:avLst/>
          </a:prstGeom>
        </p:spPr>
      </p:pic>
      <p:pic>
        <p:nvPicPr>
          <p:cNvPr id="3" name="Picture 2" descr="A graph with a line&#10;&#10;Description automatically generated">
            <a:extLst>
              <a:ext uri="{FF2B5EF4-FFF2-40B4-BE49-F238E27FC236}">
                <a16:creationId xmlns:a16="http://schemas.microsoft.com/office/drawing/2014/main" id="{538F40A1-6153-E239-1662-B7357FA555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74659"/>
            <a:ext cx="1994170" cy="1994170"/>
          </a:xfrm>
          <a:prstGeom prst="rect">
            <a:avLst/>
          </a:prstGeom>
        </p:spPr>
      </p:pic>
      <p:pic>
        <p:nvPicPr>
          <p:cNvPr id="8" name="Picture 7" descr="A graph of a line&#10;&#10;Description automatically generated">
            <a:extLst>
              <a:ext uri="{FF2B5EF4-FFF2-40B4-BE49-F238E27FC236}">
                <a16:creationId xmlns:a16="http://schemas.microsoft.com/office/drawing/2014/main" id="{A1793D5C-842E-DD4F-142F-84C5FEF6AC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95747" y="874659"/>
            <a:ext cx="1994170" cy="1994170"/>
          </a:xfrm>
          <a:prstGeom prst="rect">
            <a:avLst/>
          </a:prstGeom>
        </p:spPr>
      </p:pic>
      <p:pic>
        <p:nvPicPr>
          <p:cNvPr id="10" name="Picture 9" descr="A graph with a line&#10;&#10;Description automatically generated">
            <a:extLst>
              <a:ext uri="{FF2B5EF4-FFF2-40B4-BE49-F238E27FC236}">
                <a16:creationId xmlns:a16="http://schemas.microsoft.com/office/drawing/2014/main" id="{FF5780DA-5DBA-A883-6B12-705EF5A022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" y="2868829"/>
            <a:ext cx="1994171" cy="1994171"/>
          </a:xfrm>
          <a:prstGeom prst="rect">
            <a:avLst/>
          </a:prstGeom>
        </p:spPr>
      </p:pic>
      <p:pic>
        <p:nvPicPr>
          <p:cNvPr id="12" name="Picture 11" descr="A graph with a line&#10;&#10;Description automatically generated">
            <a:extLst>
              <a:ext uri="{FF2B5EF4-FFF2-40B4-BE49-F238E27FC236}">
                <a16:creationId xmlns:a16="http://schemas.microsoft.com/office/drawing/2014/main" id="{C62BB343-4B36-981C-9125-8982C856F2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95746" y="2868829"/>
            <a:ext cx="1994171" cy="1994171"/>
          </a:xfrm>
          <a:prstGeom prst="rect">
            <a:avLst/>
          </a:prstGeom>
        </p:spPr>
      </p:pic>
      <p:sp>
        <p:nvSpPr>
          <p:cNvPr id="2" name="Google Shape;116;p21">
            <a:extLst>
              <a:ext uri="{FF2B5EF4-FFF2-40B4-BE49-F238E27FC236}">
                <a16:creationId xmlns:a16="http://schemas.microsoft.com/office/drawing/2014/main" id="{C6BE9C28-0BA1-16BC-4649-92EF0F5F4D7C}"/>
              </a:ext>
            </a:extLst>
          </p:cNvPr>
          <p:cNvSpPr txBox="1"/>
          <p:nvPr/>
        </p:nvSpPr>
        <p:spPr>
          <a:xfrm>
            <a:off x="-101577" y="566877"/>
            <a:ext cx="5181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A</a:t>
            </a:r>
            <a:endParaRPr/>
          </a:p>
        </p:txBody>
      </p:sp>
      <p:sp>
        <p:nvSpPr>
          <p:cNvPr id="5" name="Google Shape;117;p21">
            <a:extLst>
              <a:ext uri="{FF2B5EF4-FFF2-40B4-BE49-F238E27FC236}">
                <a16:creationId xmlns:a16="http://schemas.microsoft.com/office/drawing/2014/main" id="{B656D317-C7DF-AF83-3A5F-67BF228021B8}"/>
              </a:ext>
            </a:extLst>
          </p:cNvPr>
          <p:cNvSpPr txBox="1"/>
          <p:nvPr/>
        </p:nvSpPr>
        <p:spPr>
          <a:xfrm>
            <a:off x="5781544" y="566877"/>
            <a:ext cx="4365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dirty="0"/>
              <a:t>B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534231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6EC2E-FC87-3953-DFAB-68600ABD0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-19608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6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9F66C9F-EFE6-4D0C-7890-9C1DB62D3AA0}"/>
              </a:ext>
            </a:extLst>
          </p:cNvPr>
          <p:cNvGrpSpPr/>
          <p:nvPr/>
        </p:nvGrpSpPr>
        <p:grpSpPr>
          <a:xfrm>
            <a:off x="2925095" y="743750"/>
            <a:ext cx="2635448" cy="3744442"/>
            <a:chOff x="7248443" y="435973"/>
            <a:chExt cx="2635448" cy="374444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04DE5EC-EE50-1A9B-A485-D12F542DA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85202" y="595551"/>
              <a:ext cx="2498689" cy="358486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3AC24EF-D664-CB6F-8892-4657AEF68BF1}"/>
                </a:ext>
              </a:extLst>
            </p:cNvPr>
            <p:cNvSpPr txBox="1"/>
            <p:nvPr/>
          </p:nvSpPr>
          <p:spPr>
            <a:xfrm>
              <a:off x="7248443" y="435973"/>
              <a:ext cx="3565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L" dirty="0"/>
                <a:t>C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8626FF2-2218-11F9-3FEA-1EDD5F37AC62}"/>
              </a:ext>
            </a:extLst>
          </p:cNvPr>
          <p:cNvGrpSpPr/>
          <p:nvPr/>
        </p:nvGrpSpPr>
        <p:grpSpPr>
          <a:xfrm>
            <a:off x="311700" y="744313"/>
            <a:ext cx="2709582" cy="1768563"/>
            <a:chOff x="4618485" y="523777"/>
            <a:chExt cx="2709582" cy="176856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6DD35A9-6B42-42FA-7D4C-950B8DBDAC7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00504" y="675658"/>
              <a:ext cx="2327563" cy="161668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0E14A5F-2234-462B-F6FC-77F2A613212A}"/>
                </a:ext>
              </a:extLst>
            </p:cNvPr>
            <p:cNvSpPr txBox="1"/>
            <p:nvPr/>
          </p:nvSpPr>
          <p:spPr>
            <a:xfrm>
              <a:off x="4618485" y="523777"/>
              <a:ext cx="3565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L" dirty="0"/>
                <a:t>A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017451F-769C-D425-F938-948510D7D96E}"/>
              </a:ext>
            </a:extLst>
          </p:cNvPr>
          <p:cNvGrpSpPr/>
          <p:nvPr/>
        </p:nvGrpSpPr>
        <p:grpSpPr>
          <a:xfrm>
            <a:off x="311700" y="2468061"/>
            <a:ext cx="2767487" cy="1749190"/>
            <a:chOff x="7452573" y="521404"/>
            <a:chExt cx="2767487" cy="174919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D33AB4C-6F96-BF82-7741-8D1AFBD955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49200" y="593692"/>
              <a:ext cx="2570860" cy="1676902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158E59B-F5AC-B8FB-217F-95B4A5B7F8B6}"/>
                </a:ext>
              </a:extLst>
            </p:cNvPr>
            <p:cNvSpPr txBox="1"/>
            <p:nvPr/>
          </p:nvSpPr>
          <p:spPr>
            <a:xfrm>
              <a:off x="7452573" y="521404"/>
              <a:ext cx="3565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L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056524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123CE789-1B6D-C129-4953-DBFDCC28FF8A}"/>
              </a:ext>
            </a:extLst>
          </p:cNvPr>
          <p:cNvSpPr txBox="1">
            <a:spLocks/>
          </p:cNvSpPr>
          <p:nvPr/>
        </p:nvSpPr>
        <p:spPr>
          <a:xfrm>
            <a:off x="311700" y="115681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r>
              <a:rPr lang="en-NL" dirty="0"/>
              <a:t>Supplemental</a:t>
            </a:r>
            <a:r>
              <a:rPr lang="en-US" dirty="0"/>
              <a:t> figure 7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FA175E2-0059-22BE-E160-928B246C4C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3814" y="1174204"/>
            <a:ext cx="4949614" cy="2476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95501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90F44-6937-6B48-8615-B6700E0694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0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8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3E6B335-D475-C786-8A20-D59C00ECB7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8073" y="592994"/>
            <a:ext cx="3576481" cy="394646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9D57498-8872-4395-DA47-18826D06B9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5947" y="603023"/>
            <a:ext cx="3576481" cy="392640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329794D-F027-EBB3-4B3A-A7219E531D3C}"/>
              </a:ext>
            </a:extLst>
          </p:cNvPr>
          <p:cNvSpPr txBox="1"/>
          <p:nvPr/>
        </p:nvSpPr>
        <p:spPr>
          <a:xfrm>
            <a:off x="841572" y="568171"/>
            <a:ext cx="356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64DFD38-983B-4FBA-BE3C-81A7E31E4681}"/>
              </a:ext>
            </a:extLst>
          </p:cNvPr>
          <p:cNvSpPr txBox="1"/>
          <p:nvPr/>
        </p:nvSpPr>
        <p:spPr>
          <a:xfrm>
            <a:off x="4793948" y="568170"/>
            <a:ext cx="356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L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0306471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90F44-6937-6B48-8615-B6700E0694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1700" y="0"/>
            <a:ext cx="8520600" cy="572700"/>
          </a:xfrm>
        </p:spPr>
        <p:txBody>
          <a:bodyPr/>
          <a:lstStyle/>
          <a:p>
            <a:r>
              <a:rPr lang="en-NL" dirty="0"/>
              <a:t>Supplemental</a:t>
            </a:r>
            <a:r>
              <a:rPr lang="en-US" dirty="0"/>
              <a:t> figure 9</a:t>
            </a:r>
          </a:p>
        </p:txBody>
      </p:sp>
      <p:pic>
        <p:nvPicPr>
          <p:cNvPr id="18" name="Picture 17" descr="A diagram of a bar graph&#10;&#10;Description automatically generated with medium confidence">
            <a:extLst>
              <a:ext uri="{FF2B5EF4-FFF2-40B4-BE49-F238E27FC236}">
                <a16:creationId xmlns:a16="http://schemas.microsoft.com/office/drawing/2014/main" id="{99E2363C-D59B-7C07-F595-983E56BEC5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88446"/>
            <a:ext cx="9144000" cy="3137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7009971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75</TotalTime>
  <Words>58</Words>
  <Application>Microsoft Macintosh PowerPoint</Application>
  <PresentationFormat>On-screen Show (16:9)</PresentationFormat>
  <Paragraphs>32</Paragraphs>
  <Slides>12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4" baseType="lpstr">
      <vt:lpstr>Arial</vt:lpstr>
      <vt:lpstr>Simple Light</vt:lpstr>
      <vt:lpstr>Supplemental figure 1</vt:lpstr>
      <vt:lpstr>Supplemental figure 2</vt:lpstr>
      <vt:lpstr>Supplemental figure 3</vt:lpstr>
      <vt:lpstr>Supplemental figure 4</vt:lpstr>
      <vt:lpstr>Supplemental figure 5</vt:lpstr>
      <vt:lpstr>Supplemental figure 6</vt:lpstr>
      <vt:lpstr>PowerPoint Presentation</vt:lpstr>
      <vt:lpstr>Supplemental figure 8</vt:lpstr>
      <vt:lpstr>Supplemental figure 9</vt:lpstr>
      <vt:lpstr>Supplemental figure 10</vt:lpstr>
      <vt:lpstr>Supplemental figure 11</vt:lpstr>
      <vt:lpstr>Supplemental figure 1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date isoseq project</dc:title>
  <cp:lastModifiedBy>Vorsteveld, Emil</cp:lastModifiedBy>
  <cp:revision>2</cp:revision>
  <dcterms:modified xsi:type="dcterms:W3CDTF">2024-02-14T12:13:24Z</dcterms:modified>
</cp:coreProperties>
</file>